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1" r:id="rId2"/>
    <p:sldId id="265" r:id="rId3"/>
    <p:sldId id="267" r:id="rId4"/>
    <p:sldId id="257" r:id="rId5"/>
    <p:sldId id="263" r:id="rId6"/>
    <p:sldId id="258" r:id="rId7"/>
    <p:sldId id="264" r:id="rId8"/>
    <p:sldId id="260" r:id="rId9"/>
    <p:sldId id="262" r:id="rId10"/>
    <p:sldId id="266" r:id="rId11"/>
  </p:sldIdLst>
  <p:sldSz cx="6480175" cy="6119813"/>
  <p:notesSz cx="6858000" cy="9144000"/>
  <p:defaultTextStyle>
    <a:defPPr>
      <a:defRPr lang="en-US"/>
    </a:defPPr>
    <a:lvl1pPr marL="0" algn="l" defTabSz="604784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1pPr>
    <a:lvl2pPr marL="302392" algn="l" defTabSz="604784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2pPr>
    <a:lvl3pPr marL="604784" algn="l" defTabSz="604784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3pPr>
    <a:lvl4pPr marL="907176" algn="l" defTabSz="604784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4pPr>
    <a:lvl5pPr marL="1209568" algn="l" defTabSz="604784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5pPr>
    <a:lvl6pPr marL="1511960" algn="l" defTabSz="604784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6pPr>
    <a:lvl7pPr marL="1814352" algn="l" defTabSz="604784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7pPr>
    <a:lvl8pPr marL="2116745" algn="l" defTabSz="604784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8pPr>
    <a:lvl9pPr marL="2419137" algn="l" defTabSz="604784" rtl="0" eaLnBrk="1" latinLnBrk="0" hangingPunct="1">
      <a:defRPr sz="119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212F"/>
    <a:srgbClr val="C0C0C0"/>
    <a:srgbClr val="1052BD"/>
    <a:srgbClr val="AFAFB2"/>
    <a:srgbClr val="883355"/>
    <a:srgbClr val="2AB703"/>
    <a:srgbClr val="F1252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791" autoAdjust="0"/>
    <p:restoredTop sz="95867" autoAdjust="0"/>
  </p:normalViewPr>
  <p:slideViewPr>
    <p:cSldViewPr snapToGrid="0">
      <p:cViewPr>
        <p:scale>
          <a:sx n="98" d="100"/>
          <a:sy n="98" d="100"/>
        </p:scale>
        <p:origin x="2400" y="480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ED9950-A455-4880-A357-06459BF48E46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95463" y="1143000"/>
            <a:ext cx="3267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522DF2-812C-4470-BB32-DC355F6B0C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5454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04784" rtl="0" eaLnBrk="1" latinLnBrk="0" hangingPunct="1">
      <a:defRPr sz="794" kern="1200">
        <a:solidFill>
          <a:schemeClr val="tx1"/>
        </a:solidFill>
        <a:latin typeface="+mn-lt"/>
        <a:ea typeface="+mn-ea"/>
        <a:cs typeface="+mn-cs"/>
      </a:defRPr>
    </a:lvl1pPr>
    <a:lvl2pPr marL="302392" algn="l" defTabSz="604784" rtl="0" eaLnBrk="1" latinLnBrk="0" hangingPunct="1">
      <a:defRPr sz="794" kern="1200">
        <a:solidFill>
          <a:schemeClr val="tx1"/>
        </a:solidFill>
        <a:latin typeface="+mn-lt"/>
        <a:ea typeface="+mn-ea"/>
        <a:cs typeface="+mn-cs"/>
      </a:defRPr>
    </a:lvl2pPr>
    <a:lvl3pPr marL="604784" algn="l" defTabSz="604784" rtl="0" eaLnBrk="1" latinLnBrk="0" hangingPunct="1">
      <a:defRPr sz="794" kern="1200">
        <a:solidFill>
          <a:schemeClr val="tx1"/>
        </a:solidFill>
        <a:latin typeface="+mn-lt"/>
        <a:ea typeface="+mn-ea"/>
        <a:cs typeface="+mn-cs"/>
      </a:defRPr>
    </a:lvl3pPr>
    <a:lvl4pPr marL="907176" algn="l" defTabSz="604784" rtl="0" eaLnBrk="1" latinLnBrk="0" hangingPunct="1">
      <a:defRPr sz="794" kern="1200">
        <a:solidFill>
          <a:schemeClr val="tx1"/>
        </a:solidFill>
        <a:latin typeface="+mn-lt"/>
        <a:ea typeface="+mn-ea"/>
        <a:cs typeface="+mn-cs"/>
      </a:defRPr>
    </a:lvl4pPr>
    <a:lvl5pPr marL="1209568" algn="l" defTabSz="604784" rtl="0" eaLnBrk="1" latinLnBrk="0" hangingPunct="1">
      <a:defRPr sz="794" kern="1200">
        <a:solidFill>
          <a:schemeClr val="tx1"/>
        </a:solidFill>
        <a:latin typeface="+mn-lt"/>
        <a:ea typeface="+mn-ea"/>
        <a:cs typeface="+mn-cs"/>
      </a:defRPr>
    </a:lvl5pPr>
    <a:lvl6pPr marL="1511960" algn="l" defTabSz="604784" rtl="0" eaLnBrk="1" latinLnBrk="0" hangingPunct="1">
      <a:defRPr sz="794" kern="1200">
        <a:solidFill>
          <a:schemeClr val="tx1"/>
        </a:solidFill>
        <a:latin typeface="+mn-lt"/>
        <a:ea typeface="+mn-ea"/>
        <a:cs typeface="+mn-cs"/>
      </a:defRPr>
    </a:lvl6pPr>
    <a:lvl7pPr marL="1814352" algn="l" defTabSz="604784" rtl="0" eaLnBrk="1" latinLnBrk="0" hangingPunct="1">
      <a:defRPr sz="794" kern="1200">
        <a:solidFill>
          <a:schemeClr val="tx1"/>
        </a:solidFill>
        <a:latin typeface="+mn-lt"/>
        <a:ea typeface="+mn-ea"/>
        <a:cs typeface="+mn-cs"/>
      </a:defRPr>
    </a:lvl7pPr>
    <a:lvl8pPr marL="2116745" algn="l" defTabSz="604784" rtl="0" eaLnBrk="1" latinLnBrk="0" hangingPunct="1">
      <a:defRPr sz="794" kern="1200">
        <a:solidFill>
          <a:schemeClr val="tx1"/>
        </a:solidFill>
        <a:latin typeface="+mn-lt"/>
        <a:ea typeface="+mn-ea"/>
        <a:cs typeface="+mn-cs"/>
      </a:defRPr>
    </a:lvl8pPr>
    <a:lvl9pPr marL="2419137" algn="l" defTabSz="604784" rtl="0" eaLnBrk="1" latinLnBrk="0" hangingPunct="1">
      <a:defRPr sz="79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795463" y="1143000"/>
            <a:ext cx="32670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dirty="0"/>
              <a:t>S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E48065-F0AD-4DBB-AEC0-EEFD2E1CC04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9673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E48065-F0AD-4DBB-AEC0-EEFD2E1CC04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8539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795463" y="1143000"/>
            <a:ext cx="32670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48065-F0AD-4DBB-AEC0-EEFD2E1CC04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595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795463" y="1143000"/>
            <a:ext cx="32670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E48065-F0AD-4DBB-AEC0-EEFD2E1CC04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4343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795463" y="1143000"/>
            <a:ext cx="32670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E48065-F0AD-4DBB-AEC0-EEFD2E1CC04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2197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0022" y="1001553"/>
            <a:ext cx="4860131" cy="213060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3214319"/>
            <a:ext cx="4860131" cy="1477538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493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089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325823"/>
            <a:ext cx="1397288" cy="51862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325823"/>
            <a:ext cx="4110861" cy="518625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93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658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525704"/>
            <a:ext cx="5589151" cy="254567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4095459"/>
            <a:ext cx="5589151" cy="133870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481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629117"/>
            <a:ext cx="2754074" cy="388296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629117"/>
            <a:ext cx="2754074" cy="388296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745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25824"/>
            <a:ext cx="5589151" cy="118288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6" y="1500205"/>
            <a:ext cx="2741418" cy="73522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6" y="2235432"/>
            <a:ext cx="2741418" cy="32879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500205"/>
            <a:ext cx="2754918" cy="73522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235432"/>
            <a:ext cx="2754918" cy="32879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547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342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870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07988"/>
            <a:ext cx="2090025" cy="1427956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881140"/>
            <a:ext cx="3280589" cy="434903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835944"/>
            <a:ext cx="2090025" cy="340131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804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07988"/>
            <a:ext cx="2090025" cy="1427956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754918" y="881140"/>
            <a:ext cx="3280589" cy="4349034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835944"/>
            <a:ext cx="2090025" cy="340131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570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325824"/>
            <a:ext cx="5589151" cy="1182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629117"/>
            <a:ext cx="5589151" cy="38829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5672161"/>
            <a:ext cx="1458039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8652B-16D4-411B-8CAE-42C05FF9F828}" type="datetimeFigureOut">
              <a:rPr lang="en-US" smtClean="0"/>
              <a:t>12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5672161"/>
            <a:ext cx="2187059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5672161"/>
            <a:ext cx="1458039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D0DB2-34B5-4C4B-9AE3-20DED2BE2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626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8.bin"/><Relationship Id="rId18" Type="http://schemas.openxmlformats.org/officeDocument/2006/relationships/image" Target="../media/image14.emf"/><Relationship Id="rId26" Type="http://schemas.openxmlformats.org/officeDocument/2006/relationships/image" Target="../media/image18.emf"/><Relationship Id="rId39" Type="http://schemas.openxmlformats.org/officeDocument/2006/relationships/oleObject" Target="../embeddings/oleObject21.bin"/><Relationship Id="rId21" Type="http://schemas.openxmlformats.org/officeDocument/2006/relationships/oleObject" Target="../embeddings/oleObject12.bin"/><Relationship Id="rId34" Type="http://schemas.openxmlformats.org/officeDocument/2006/relationships/image" Target="../media/image22.emf"/><Relationship Id="rId42" Type="http://schemas.openxmlformats.org/officeDocument/2006/relationships/image" Target="../media/image26.emf"/><Relationship Id="rId47" Type="http://schemas.openxmlformats.org/officeDocument/2006/relationships/oleObject" Target="../embeddings/oleObject25.bin"/><Relationship Id="rId50" Type="http://schemas.openxmlformats.org/officeDocument/2006/relationships/image" Target="../media/image30.emf"/><Relationship Id="rId55" Type="http://schemas.openxmlformats.org/officeDocument/2006/relationships/oleObject" Target="../embeddings/oleObject29.bin"/><Relationship Id="rId7" Type="http://schemas.openxmlformats.org/officeDocument/2006/relationships/oleObject" Target="../embeddings/oleObject5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3.emf"/><Relationship Id="rId29" Type="http://schemas.openxmlformats.org/officeDocument/2006/relationships/oleObject" Target="../embeddings/oleObject16.bin"/><Relationship Id="rId11" Type="http://schemas.openxmlformats.org/officeDocument/2006/relationships/oleObject" Target="../embeddings/oleObject7.bin"/><Relationship Id="rId24" Type="http://schemas.openxmlformats.org/officeDocument/2006/relationships/image" Target="../media/image17.emf"/><Relationship Id="rId32" Type="http://schemas.openxmlformats.org/officeDocument/2006/relationships/image" Target="../media/image21.emf"/><Relationship Id="rId37" Type="http://schemas.openxmlformats.org/officeDocument/2006/relationships/oleObject" Target="../embeddings/oleObject20.bin"/><Relationship Id="rId40" Type="http://schemas.openxmlformats.org/officeDocument/2006/relationships/image" Target="../media/image25.emf"/><Relationship Id="rId45" Type="http://schemas.openxmlformats.org/officeDocument/2006/relationships/oleObject" Target="../embeddings/oleObject24.bin"/><Relationship Id="rId53" Type="http://schemas.openxmlformats.org/officeDocument/2006/relationships/oleObject" Target="../embeddings/oleObject28.bin"/><Relationship Id="rId58" Type="http://schemas.openxmlformats.org/officeDocument/2006/relationships/image" Target="../media/image34.emf"/><Relationship Id="rId5" Type="http://schemas.openxmlformats.org/officeDocument/2006/relationships/oleObject" Target="../embeddings/oleObject4.bin"/><Relationship Id="rId19" Type="http://schemas.openxmlformats.org/officeDocument/2006/relationships/oleObject" Target="../embeddings/oleObject11.bin"/><Relationship Id="rId4" Type="http://schemas.openxmlformats.org/officeDocument/2006/relationships/image" Target="../media/image7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12.emf"/><Relationship Id="rId22" Type="http://schemas.openxmlformats.org/officeDocument/2006/relationships/image" Target="../media/image16.emf"/><Relationship Id="rId27" Type="http://schemas.openxmlformats.org/officeDocument/2006/relationships/oleObject" Target="../embeddings/oleObject15.bin"/><Relationship Id="rId30" Type="http://schemas.openxmlformats.org/officeDocument/2006/relationships/image" Target="../media/image20.emf"/><Relationship Id="rId35" Type="http://schemas.openxmlformats.org/officeDocument/2006/relationships/oleObject" Target="../embeddings/oleObject19.bin"/><Relationship Id="rId43" Type="http://schemas.openxmlformats.org/officeDocument/2006/relationships/oleObject" Target="../embeddings/oleObject23.bin"/><Relationship Id="rId48" Type="http://schemas.openxmlformats.org/officeDocument/2006/relationships/image" Target="../media/image29.emf"/><Relationship Id="rId56" Type="http://schemas.openxmlformats.org/officeDocument/2006/relationships/image" Target="../media/image33.emf"/><Relationship Id="rId8" Type="http://schemas.openxmlformats.org/officeDocument/2006/relationships/image" Target="../media/image9.emf"/><Relationship Id="rId51" Type="http://schemas.openxmlformats.org/officeDocument/2006/relationships/oleObject" Target="../embeddings/oleObject27.bin"/><Relationship Id="rId3" Type="http://schemas.openxmlformats.org/officeDocument/2006/relationships/oleObject" Target="../embeddings/oleObject3.bin"/><Relationship Id="rId12" Type="http://schemas.openxmlformats.org/officeDocument/2006/relationships/image" Target="../media/image11.emf"/><Relationship Id="rId17" Type="http://schemas.openxmlformats.org/officeDocument/2006/relationships/oleObject" Target="../embeddings/oleObject10.bin"/><Relationship Id="rId25" Type="http://schemas.openxmlformats.org/officeDocument/2006/relationships/oleObject" Target="../embeddings/oleObject14.bin"/><Relationship Id="rId33" Type="http://schemas.openxmlformats.org/officeDocument/2006/relationships/oleObject" Target="../embeddings/oleObject18.bin"/><Relationship Id="rId38" Type="http://schemas.openxmlformats.org/officeDocument/2006/relationships/image" Target="../media/image24.emf"/><Relationship Id="rId46" Type="http://schemas.openxmlformats.org/officeDocument/2006/relationships/image" Target="../media/image28.emf"/><Relationship Id="rId20" Type="http://schemas.openxmlformats.org/officeDocument/2006/relationships/image" Target="../media/image15.emf"/><Relationship Id="rId41" Type="http://schemas.openxmlformats.org/officeDocument/2006/relationships/oleObject" Target="../embeddings/oleObject22.bin"/><Relationship Id="rId54" Type="http://schemas.openxmlformats.org/officeDocument/2006/relationships/image" Target="../media/image3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15" Type="http://schemas.openxmlformats.org/officeDocument/2006/relationships/oleObject" Target="../embeddings/oleObject9.bin"/><Relationship Id="rId23" Type="http://schemas.openxmlformats.org/officeDocument/2006/relationships/oleObject" Target="../embeddings/oleObject13.bin"/><Relationship Id="rId28" Type="http://schemas.openxmlformats.org/officeDocument/2006/relationships/image" Target="../media/image19.emf"/><Relationship Id="rId36" Type="http://schemas.openxmlformats.org/officeDocument/2006/relationships/image" Target="../media/image23.emf"/><Relationship Id="rId49" Type="http://schemas.openxmlformats.org/officeDocument/2006/relationships/oleObject" Target="../embeddings/oleObject26.bin"/><Relationship Id="rId57" Type="http://schemas.openxmlformats.org/officeDocument/2006/relationships/oleObject" Target="../embeddings/oleObject30.bin"/><Relationship Id="rId10" Type="http://schemas.openxmlformats.org/officeDocument/2006/relationships/image" Target="../media/image10.emf"/><Relationship Id="rId31" Type="http://schemas.openxmlformats.org/officeDocument/2006/relationships/oleObject" Target="../embeddings/oleObject17.bin"/><Relationship Id="rId44" Type="http://schemas.openxmlformats.org/officeDocument/2006/relationships/image" Target="../media/image27.emf"/><Relationship Id="rId52" Type="http://schemas.openxmlformats.org/officeDocument/2006/relationships/image" Target="../media/image31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36.bin"/><Relationship Id="rId18" Type="http://schemas.openxmlformats.org/officeDocument/2006/relationships/image" Target="../media/image42.emf"/><Relationship Id="rId26" Type="http://schemas.openxmlformats.org/officeDocument/2006/relationships/oleObject" Target="../embeddings/oleObject41.bin"/><Relationship Id="rId39" Type="http://schemas.openxmlformats.org/officeDocument/2006/relationships/image" Target="../media/image54.emf"/><Relationship Id="rId21" Type="http://schemas.openxmlformats.org/officeDocument/2006/relationships/image" Target="../media/image45.tiff"/><Relationship Id="rId34" Type="http://schemas.openxmlformats.org/officeDocument/2006/relationships/oleObject" Target="../embeddings/oleObject45.bin"/><Relationship Id="rId42" Type="http://schemas.openxmlformats.org/officeDocument/2006/relationships/oleObject" Target="../embeddings/oleObject49.bin"/><Relationship Id="rId47" Type="http://schemas.openxmlformats.org/officeDocument/2006/relationships/image" Target="../media/image58.emf"/><Relationship Id="rId50" Type="http://schemas.openxmlformats.org/officeDocument/2006/relationships/oleObject" Target="../embeddings/oleObject53.bin"/><Relationship Id="rId7" Type="http://schemas.openxmlformats.org/officeDocument/2006/relationships/oleObject" Target="../embeddings/oleObject33.bin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41.emf"/><Relationship Id="rId29" Type="http://schemas.openxmlformats.org/officeDocument/2006/relationships/image" Target="../media/image49.emf"/><Relationship Id="rId11" Type="http://schemas.openxmlformats.org/officeDocument/2006/relationships/oleObject" Target="../embeddings/oleObject35.bin"/><Relationship Id="rId24" Type="http://schemas.openxmlformats.org/officeDocument/2006/relationships/oleObject" Target="../embeddings/oleObject40.bin"/><Relationship Id="rId32" Type="http://schemas.openxmlformats.org/officeDocument/2006/relationships/oleObject" Target="../embeddings/oleObject44.bin"/><Relationship Id="rId37" Type="http://schemas.openxmlformats.org/officeDocument/2006/relationships/image" Target="../media/image53.emf"/><Relationship Id="rId40" Type="http://schemas.openxmlformats.org/officeDocument/2006/relationships/oleObject" Target="../embeddings/oleObject48.bin"/><Relationship Id="rId45" Type="http://schemas.openxmlformats.org/officeDocument/2006/relationships/image" Target="../media/image57.emf"/><Relationship Id="rId53" Type="http://schemas.openxmlformats.org/officeDocument/2006/relationships/image" Target="../media/image61.emf"/><Relationship Id="rId5" Type="http://schemas.openxmlformats.org/officeDocument/2006/relationships/oleObject" Target="../embeddings/oleObject32.bin"/><Relationship Id="rId10" Type="http://schemas.openxmlformats.org/officeDocument/2006/relationships/image" Target="../media/image38.emf"/><Relationship Id="rId19" Type="http://schemas.openxmlformats.org/officeDocument/2006/relationships/image" Target="../media/image43.tiff"/><Relationship Id="rId31" Type="http://schemas.openxmlformats.org/officeDocument/2006/relationships/image" Target="../media/image50.emf"/><Relationship Id="rId44" Type="http://schemas.openxmlformats.org/officeDocument/2006/relationships/oleObject" Target="../embeddings/oleObject50.bin"/><Relationship Id="rId52" Type="http://schemas.openxmlformats.org/officeDocument/2006/relationships/oleObject" Target="../embeddings/oleObject54.bin"/><Relationship Id="rId4" Type="http://schemas.openxmlformats.org/officeDocument/2006/relationships/image" Target="../media/image35.emf"/><Relationship Id="rId9" Type="http://schemas.openxmlformats.org/officeDocument/2006/relationships/oleObject" Target="../embeddings/oleObject34.bin"/><Relationship Id="rId14" Type="http://schemas.openxmlformats.org/officeDocument/2006/relationships/image" Target="../media/image40.emf"/><Relationship Id="rId22" Type="http://schemas.openxmlformats.org/officeDocument/2006/relationships/oleObject" Target="../embeddings/oleObject39.bin"/><Relationship Id="rId27" Type="http://schemas.openxmlformats.org/officeDocument/2006/relationships/image" Target="../media/image48.emf"/><Relationship Id="rId30" Type="http://schemas.openxmlformats.org/officeDocument/2006/relationships/oleObject" Target="../embeddings/oleObject43.bin"/><Relationship Id="rId35" Type="http://schemas.openxmlformats.org/officeDocument/2006/relationships/image" Target="../media/image52.emf"/><Relationship Id="rId43" Type="http://schemas.openxmlformats.org/officeDocument/2006/relationships/image" Target="../media/image56.emf"/><Relationship Id="rId48" Type="http://schemas.openxmlformats.org/officeDocument/2006/relationships/oleObject" Target="../embeddings/oleObject52.bin"/><Relationship Id="rId8" Type="http://schemas.openxmlformats.org/officeDocument/2006/relationships/image" Target="../media/image37.emf"/><Relationship Id="rId51" Type="http://schemas.openxmlformats.org/officeDocument/2006/relationships/image" Target="../media/image60.emf"/><Relationship Id="rId3" Type="http://schemas.openxmlformats.org/officeDocument/2006/relationships/oleObject" Target="../embeddings/oleObject31.bin"/><Relationship Id="rId12" Type="http://schemas.openxmlformats.org/officeDocument/2006/relationships/image" Target="../media/image39.emf"/><Relationship Id="rId17" Type="http://schemas.openxmlformats.org/officeDocument/2006/relationships/oleObject" Target="../embeddings/oleObject38.bin"/><Relationship Id="rId25" Type="http://schemas.openxmlformats.org/officeDocument/2006/relationships/image" Target="../media/image47.emf"/><Relationship Id="rId33" Type="http://schemas.openxmlformats.org/officeDocument/2006/relationships/image" Target="../media/image51.emf"/><Relationship Id="rId38" Type="http://schemas.openxmlformats.org/officeDocument/2006/relationships/oleObject" Target="../embeddings/oleObject47.bin"/><Relationship Id="rId46" Type="http://schemas.openxmlformats.org/officeDocument/2006/relationships/oleObject" Target="../embeddings/oleObject51.bin"/><Relationship Id="rId20" Type="http://schemas.openxmlformats.org/officeDocument/2006/relationships/image" Target="../media/image44.tiff"/><Relationship Id="rId41" Type="http://schemas.openxmlformats.org/officeDocument/2006/relationships/image" Target="../media/image5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emf"/><Relationship Id="rId15" Type="http://schemas.openxmlformats.org/officeDocument/2006/relationships/oleObject" Target="../embeddings/oleObject37.bin"/><Relationship Id="rId23" Type="http://schemas.openxmlformats.org/officeDocument/2006/relationships/image" Target="../media/image46.emf"/><Relationship Id="rId28" Type="http://schemas.openxmlformats.org/officeDocument/2006/relationships/oleObject" Target="../embeddings/oleObject42.bin"/><Relationship Id="rId36" Type="http://schemas.openxmlformats.org/officeDocument/2006/relationships/oleObject" Target="../embeddings/oleObject46.bin"/><Relationship Id="rId49" Type="http://schemas.openxmlformats.org/officeDocument/2006/relationships/image" Target="../media/image59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emf"/><Relationship Id="rId13" Type="http://schemas.openxmlformats.org/officeDocument/2006/relationships/oleObject" Target="../embeddings/oleObject60.bin"/><Relationship Id="rId3" Type="http://schemas.openxmlformats.org/officeDocument/2006/relationships/oleObject" Target="../embeddings/oleObject55.bin"/><Relationship Id="rId7" Type="http://schemas.openxmlformats.org/officeDocument/2006/relationships/oleObject" Target="../embeddings/oleObject57.bin"/><Relationship Id="rId12" Type="http://schemas.openxmlformats.org/officeDocument/2006/relationships/image" Target="../media/image6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emf"/><Relationship Id="rId11" Type="http://schemas.openxmlformats.org/officeDocument/2006/relationships/oleObject" Target="../embeddings/oleObject59.bin"/><Relationship Id="rId5" Type="http://schemas.openxmlformats.org/officeDocument/2006/relationships/oleObject" Target="../embeddings/oleObject56.bin"/><Relationship Id="rId10" Type="http://schemas.openxmlformats.org/officeDocument/2006/relationships/image" Target="../media/image65.emf"/><Relationship Id="rId4" Type="http://schemas.openxmlformats.org/officeDocument/2006/relationships/image" Target="../media/image62.emf"/><Relationship Id="rId9" Type="http://schemas.openxmlformats.org/officeDocument/2006/relationships/oleObject" Target="../embeddings/oleObject58.bin"/><Relationship Id="rId14" Type="http://schemas.openxmlformats.org/officeDocument/2006/relationships/image" Target="../media/image67.emf"/></Relationships>
</file>

<file path=ppt/slides/_rels/slide9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66.bin"/><Relationship Id="rId18" Type="http://schemas.openxmlformats.org/officeDocument/2006/relationships/image" Target="../media/image75.emf"/><Relationship Id="rId26" Type="http://schemas.openxmlformats.org/officeDocument/2006/relationships/image" Target="../media/image79.emf"/><Relationship Id="rId39" Type="http://schemas.openxmlformats.org/officeDocument/2006/relationships/oleObject" Target="../embeddings/oleObject79.bin"/><Relationship Id="rId21" Type="http://schemas.openxmlformats.org/officeDocument/2006/relationships/oleObject" Target="../embeddings/oleObject70.bin"/><Relationship Id="rId34" Type="http://schemas.openxmlformats.org/officeDocument/2006/relationships/image" Target="../media/image83.emf"/><Relationship Id="rId42" Type="http://schemas.openxmlformats.org/officeDocument/2006/relationships/image" Target="../media/image87.emf"/><Relationship Id="rId47" Type="http://schemas.openxmlformats.org/officeDocument/2006/relationships/image" Target="../media/image92.jpeg"/><Relationship Id="rId7" Type="http://schemas.openxmlformats.org/officeDocument/2006/relationships/oleObject" Target="../embeddings/oleObject63.bin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74.emf"/><Relationship Id="rId29" Type="http://schemas.openxmlformats.org/officeDocument/2006/relationships/oleObject" Target="../embeddings/oleObject74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9.emf"/><Relationship Id="rId11" Type="http://schemas.openxmlformats.org/officeDocument/2006/relationships/oleObject" Target="../embeddings/oleObject65.bin"/><Relationship Id="rId24" Type="http://schemas.openxmlformats.org/officeDocument/2006/relationships/image" Target="../media/image78.emf"/><Relationship Id="rId32" Type="http://schemas.openxmlformats.org/officeDocument/2006/relationships/image" Target="../media/image82.emf"/><Relationship Id="rId37" Type="http://schemas.openxmlformats.org/officeDocument/2006/relationships/oleObject" Target="../embeddings/oleObject78.bin"/><Relationship Id="rId40" Type="http://schemas.openxmlformats.org/officeDocument/2006/relationships/image" Target="../media/image86.emf"/><Relationship Id="rId45" Type="http://schemas.openxmlformats.org/officeDocument/2006/relationships/image" Target="../media/image90.jpeg"/><Relationship Id="rId5" Type="http://schemas.openxmlformats.org/officeDocument/2006/relationships/oleObject" Target="../embeddings/oleObject62.bin"/><Relationship Id="rId15" Type="http://schemas.openxmlformats.org/officeDocument/2006/relationships/oleObject" Target="../embeddings/oleObject67.bin"/><Relationship Id="rId23" Type="http://schemas.openxmlformats.org/officeDocument/2006/relationships/oleObject" Target="../embeddings/oleObject71.bin"/><Relationship Id="rId28" Type="http://schemas.openxmlformats.org/officeDocument/2006/relationships/image" Target="../media/image80.emf"/><Relationship Id="rId36" Type="http://schemas.openxmlformats.org/officeDocument/2006/relationships/image" Target="../media/image84.emf"/><Relationship Id="rId10" Type="http://schemas.openxmlformats.org/officeDocument/2006/relationships/image" Target="../media/image71.emf"/><Relationship Id="rId19" Type="http://schemas.openxmlformats.org/officeDocument/2006/relationships/oleObject" Target="../embeddings/oleObject69.bin"/><Relationship Id="rId31" Type="http://schemas.openxmlformats.org/officeDocument/2006/relationships/oleObject" Target="../embeddings/oleObject75.bin"/><Relationship Id="rId44" Type="http://schemas.openxmlformats.org/officeDocument/2006/relationships/image" Target="../media/image89.jpeg"/><Relationship Id="rId4" Type="http://schemas.openxmlformats.org/officeDocument/2006/relationships/image" Target="../media/image68.emf"/><Relationship Id="rId9" Type="http://schemas.openxmlformats.org/officeDocument/2006/relationships/oleObject" Target="../embeddings/oleObject64.bin"/><Relationship Id="rId14" Type="http://schemas.openxmlformats.org/officeDocument/2006/relationships/image" Target="../media/image73.emf"/><Relationship Id="rId22" Type="http://schemas.openxmlformats.org/officeDocument/2006/relationships/image" Target="../media/image77.emf"/><Relationship Id="rId27" Type="http://schemas.openxmlformats.org/officeDocument/2006/relationships/oleObject" Target="../embeddings/oleObject73.bin"/><Relationship Id="rId30" Type="http://schemas.openxmlformats.org/officeDocument/2006/relationships/image" Target="../media/image81.emf"/><Relationship Id="rId35" Type="http://schemas.openxmlformats.org/officeDocument/2006/relationships/oleObject" Target="../embeddings/oleObject77.bin"/><Relationship Id="rId43" Type="http://schemas.openxmlformats.org/officeDocument/2006/relationships/image" Target="../media/image88.jpeg"/><Relationship Id="rId48" Type="http://schemas.openxmlformats.org/officeDocument/2006/relationships/image" Target="../media/image93.jpeg"/><Relationship Id="rId8" Type="http://schemas.openxmlformats.org/officeDocument/2006/relationships/image" Target="../media/image70.emf"/><Relationship Id="rId3" Type="http://schemas.openxmlformats.org/officeDocument/2006/relationships/oleObject" Target="../embeddings/oleObject61.bin"/><Relationship Id="rId12" Type="http://schemas.openxmlformats.org/officeDocument/2006/relationships/image" Target="../media/image72.emf"/><Relationship Id="rId17" Type="http://schemas.openxmlformats.org/officeDocument/2006/relationships/oleObject" Target="../embeddings/oleObject68.bin"/><Relationship Id="rId25" Type="http://schemas.openxmlformats.org/officeDocument/2006/relationships/oleObject" Target="../embeddings/oleObject72.bin"/><Relationship Id="rId33" Type="http://schemas.openxmlformats.org/officeDocument/2006/relationships/oleObject" Target="../embeddings/oleObject76.bin"/><Relationship Id="rId38" Type="http://schemas.openxmlformats.org/officeDocument/2006/relationships/image" Target="../media/image85.emf"/><Relationship Id="rId46" Type="http://schemas.openxmlformats.org/officeDocument/2006/relationships/image" Target="../media/image91.jpeg"/><Relationship Id="rId20" Type="http://schemas.openxmlformats.org/officeDocument/2006/relationships/image" Target="../media/image76.emf"/><Relationship Id="rId41" Type="http://schemas.openxmlformats.org/officeDocument/2006/relationships/oleObject" Target="../embeddings/oleObject8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635"/>
          <a:stretch/>
        </p:blipFill>
        <p:spPr>
          <a:xfrm>
            <a:off x="437980" y="74050"/>
            <a:ext cx="1990066" cy="196032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148190" y="125526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3016187" y="123397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3017723" y="2036445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5465518" y="156678"/>
            <a:ext cx="532518" cy="571495"/>
            <a:chOff x="5434356" y="2986400"/>
            <a:chExt cx="718527" cy="771117"/>
          </a:xfrm>
        </p:grpSpPr>
        <p:sp>
          <p:nvSpPr>
            <p:cNvPr id="34" name="Rectangle 33"/>
            <p:cNvSpPr>
              <a:spLocks/>
            </p:cNvSpPr>
            <p:nvPr/>
          </p:nvSpPr>
          <p:spPr>
            <a:xfrm>
              <a:off x="5537232" y="3036095"/>
              <a:ext cx="520954" cy="58649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434356" y="2986400"/>
              <a:ext cx="718527" cy="415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Legend:</a:t>
              </a:r>
            </a:p>
            <a:p>
              <a:pPr algn="ctr"/>
              <a:endParaRPr lang="en-US" sz="7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588398" y="3163243"/>
              <a:ext cx="469788" cy="415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  <a:p>
              <a:pPr algn="ctr"/>
              <a:endParaRPr lang="en-US" sz="7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589182" y="3342234"/>
              <a:ext cx="526024" cy="415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X31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</a:p>
            <a:p>
              <a:pPr algn="ctr"/>
              <a:endParaRPr lang="en-US" sz="700" dirty="0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5588068" y="3240369"/>
              <a:ext cx="91440" cy="91440"/>
            </a:xfrm>
            <a:prstGeom prst="rect">
              <a:avLst/>
            </a:prstGeom>
            <a:solidFill>
              <a:srgbClr val="BDBDB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33" name="Rectangle 32"/>
            <p:cNvSpPr/>
            <p:nvPr/>
          </p:nvSpPr>
          <p:spPr>
            <a:xfrm>
              <a:off x="5589176" y="3419514"/>
              <a:ext cx="91439" cy="91441"/>
            </a:xfrm>
            <a:prstGeom prst="rect">
              <a:avLst/>
            </a:prstGeom>
            <a:solidFill>
              <a:srgbClr val="88335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</p:grpSp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043"/>
          <a:stretch/>
        </p:blipFill>
        <p:spPr>
          <a:xfrm>
            <a:off x="3439666" y="43496"/>
            <a:ext cx="2020763" cy="1999414"/>
          </a:xfrm>
          <a:prstGeom prst="rect">
            <a:avLst/>
          </a:prstGeom>
        </p:spPr>
      </p:pic>
      <p:grpSp>
        <p:nvGrpSpPr>
          <p:cNvPr id="49" name="Group 48"/>
          <p:cNvGrpSpPr/>
          <p:nvPr/>
        </p:nvGrpSpPr>
        <p:grpSpPr>
          <a:xfrm>
            <a:off x="2436363" y="157475"/>
            <a:ext cx="527709" cy="571495"/>
            <a:chOff x="5437600" y="2986400"/>
            <a:chExt cx="712038" cy="771117"/>
          </a:xfrm>
        </p:grpSpPr>
        <p:sp>
          <p:nvSpPr>
            <p:cNvPr id="51" name="Rectangle 50"/>
            <p:cNvSpPr>
              <a:spLocks/>
            </p:cNvSpPr>
            <p:nvPr/>
          </p:nvSpPr>
          <p:spPr>
            <a:xfrm>
              <a:off x="5537232" y="3036095"/>
              <a:ext cx="520954" cy="58649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437600" y="2986400"/>
              <a:ext cx="712038" cy="415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Legen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</a:p>
            <a:p>
              <a:pPr algn="ctr"/>
              <a:endParaRPr lang="en-US" sz="7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588398" y="3163243"/>
              <a:ext cx="469788" cy="415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  <a:p>
              <a:pPr algn="ctr"/>
              <a:endParaRPr lang="en-US" sz="7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589182" y="3342234"/>
              <a:ext cx="526024" cy="4152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X31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</a:p>
            <a:p>
              <a:pPr algn="ctr"/>
              <a:endParaRPr lang="en-US" sz="700" dirty="0"/>
            </a:p>
          </p:txBody>
        </p:sp>
        <p:sp>
          <p:nvSpPr>
            <p:cNvPr id="55" name="Rectangle 54"/>
            <p:cNvSpPr/>
            <p:nvPr/>
          </p:nvSpPr>
          <p:spPr>
            <a:xfrm>
              <a:off x="5588068" y="3240369"/>
              <a:ext cx="91440" cy="91440"/>
            </a:xfrm>
            <a:prstGeom prst="rect">
              <a:avLst/>
            </a:prstGeom>
            <a:solidFill>
              <a:srgbClr val="BDBDB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56" name="Rectangle 55"/>
            <p:cNvSpPr/>
            <p:nvPr/>
          </p:nvSpPr>
          <p:spPr>
            <a:xfrm>
              <a:off x="5589176" y="3419514"/>
              <a:ext cx="91439" cy="91441"/>
            </a:xfrm>
            <a:prstGeom prst="rect">
              <a:avLst/>
            </a:prstGeom>
            <a:solidFill>
              <a:srgbClr val="88335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2756862" y="2115217"/>
            <a:ext cx="3613619" cy="3989356"/>
            <a:chOff x="2756862" y="2130457"/>
            <a:chExt cx="3613619" cy="398935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1A06035-4B3B-3FEE-AD33-CEF757BC84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815" r="5747" b="20311"/>
            <a:stretch/>
          </p:blipFill>
          <p:spPr>
            <a:xfrm>
              <a:off x="2756862" y="2248844"/>
              <a:ext cx="3613619" cy="295684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F231F19-3512-082F-AB47-F0F58D158F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1862" b="80067"/>
            <a:stretch/>
          </p:blipFill>
          <p:spPr>
            <a:xfrm>
              <a:off x="4254100" y="5139014"/>
              <a:ext cx="1092825" cy="980799"/>
            </a:xfrm>
            <a:prstGeom prst="rect">
              <a:avLst/>
            </a:prstGeom>
          </p:spPr>
        </p:pic>
        <p:sp>
          <p:nvSpPr>
            <p:cNvPr id="20" name="Rectangle 19"/>
            <p:cNvSpPr/>
            <p:nvPr/>
          </p:nvSpPr>
          <p:spPr>
            <a:xfrm>
              <a:off x="3751344" y="2130457"/>
              <a:ext cx="1042416" cy="171450"/>
            </a:xfrm>
            <a:prstGeom prst="rect">
              <a:avLst/>
            </a:prstGeom>
            <a:solidFill>
              <a:srgbClr val="BDBDB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4800513" y="2130457"/>
              <a:ext cx="1536192" cy="171450"/>
            </a:xfrm>
            <a:prstGeom prst="rect">
              <a:avLst/>
            </a:prstGeom>
            <a:solidFill>
              <a:srgbClr val="883355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X31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</a:p>
          </p:txBody>
        </p:sp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id="{069C38E5-9274-D896-B631-33F8DB18DEE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535" r="12648" b="16360"/>
          <a:stretch/>
        </p:blipFill>
        <p:spPr>
          <a:xfrm>
            <a:off x="367925" y="2207776"/>
            <a:ext cx="1952848" cy="1958140"/>
          </a:xfrm>
          <a:prstGeom prst="rect">
            <a:avLst/>
          </a:prstGeom>
        </p:spPr>
      </p:pic>
      <p:grpSp>
        <p:nvGrpSpPr>
          <p:cNvPr id="17" name="Group 16">
            <a:extLst>
              <a:ext uri="{FF2B5EF4-FFF2-40B4-BE49-F238E27FC236}">
                <a16:creationId xmlns:a16="http://schemas.microsoft.com/office/drawing/2014/main" id="{3F2C3B99-1928-E6EF-B029-DE6032178481}"/>
              </a:ext>
            </a:extLst>
          </p:cNvPr>
          <p:cNvGrpSpPr/>
          <p:nvPr/>
        </p:nvGrpSpPr>
        <p:grpSpPr>
          <a:xfrm>
            <a:off x="2167928" y="2076713"/>
            <a:ext cx="527709" cy="571495"/>
            <a:chOff x="2223196" y="2712163"/>
            <a:chExt cx="527709" cy="571495"/>
          </a:xfrm>
        </p:grpSpPr>
        <p:grpSp>
          <p:nvGrpSpPr>
            <p:cNvPr id="59" name="Group 58"/>
            <p:cNvGrpSpPr/>
            <p:nvPr/>
          </p:nvGrpSpPr>
          <p:grpSpPr>
            <a:xfrm>
              <a:off x="2223196" y="2712163"/>
              <a:ext cx="527709" cy="571495"/>
              <a:chOff x="5424748" y="2986400"/>
              <a:chExt cx="712038" cy="771117"/>
            </a:xfrm>
          </p:grpSpPr>
          <p:sp>
            <p:nvSpPr>
              <p:cNvPr id="61" name="Rectangle 60"/>
              <p:cNvSpPr>
                <a:spLocks/>
              </p:cNvSpPr>
              <p:nvPr/>
            </p:nvSpPr>
            <p:spPr>
              <a:xfrm>
                <a:off x="5537232" y="3036095"/>
                <a:ext cx="520954" cy="5864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424748" y="2986400"/>
                <a:ext cx="712038" cy="4152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gend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</a:p>
              <a:p>
                <a:pPr algn="ctr"/>
                <a:endParaRPr lang="en-US" sz="700" dirty="0"/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588398" y="3163243"/>
                <a:ext cx="469788" cy="4152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  <a:p>
                <a:pPr algn="ctr"/>
                <a:endParaRPr lang="en-US" sz="700" dirty="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5589182" y="3342234"/>
                <a:ext cx="526024" cy="4152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  <a:p>
                <a:pPr algn="ctr"/>
                <a:endParaRPr lang="en-US" sz="700" dirty="0"/>
              </a:p>
            </p:txBody>
          </p:sp>
        </p:grpSp>
        <p:sp>
          <p:nvSpPr>
            <p:cNvPr id="6" name="Oval 5"/>
            <p:cNvSpPr/>
            <p:nvPr/>
          </p:nvSpPr>
          <p:spPr>
            <a:xfrm>
              <a:off x="2344482" y="3055787"/>
              <a:ext cx="64008" cy="64008"/>
            </a:xfrm>
            <a:prstGeom prst="ellipse">
              <a:avLst/>
            </a:prstGeom>
            <a:solidFill>
              <a:srgbClr val="AFAFB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Oval 66"/>
            <p:cNvSpPr/>
            <p:nvPr/>
          </p:nvSpPr>
          <p:spPr>
            <a:xfrm>
              <a:off x="2345752" y="2918627"/>
              <a:ext cx="64008" cy="64008"/>
            </a:xfrm>
            <a:prstGeom prst="ellipse">
              <a:avLst/>
            </a:prstGeom>
            <a:solidFill>
              <a:srgbClr val="88335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145006" y="2039059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0257769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481A5BE-C56A-E39F-73E4-E7F9FFDB1B08}"/>
              </a:ext>
            </a:extLst>
          </p:cNvPr>
          <p:cNvSpPr txBox="1"/>
          <p:nvPr/>
        </p:nvSpPr>
        <p:spPr>
          <a:xfrm>
            <a:off x="0" y="0"/>
            <a:ext cx="6480175" cy="3785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6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in region-specific analysis of border-associated macrophages and microglia at E11.5 and 16.5. (A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ba1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06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microglia) staining of the E11.5 (2 dpi) fetal brain split into fore- and mid-brain (telencephalon, diencephalon, and mesencephalon) and hindbrain (metencephalon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yencephalon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revealed no differences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dditionally, there were no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fferences in microglia count at E16.5, 7 dpi when dividing by hemisphere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ba1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06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AM) staining of E11.5 fetal brains revealed no differences between brain regions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right hemisphere showed a slightly higher upregulation of BAMs in X31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s Con fetal brains at E16.5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(E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Representative images of the E11.5 and 16.5 fetal brain stained with Iba1 (red) and Ki67 (green). Scale bars = 100µm; arrows (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sym typeface="Wingdings" panose="05000000000000000000" pitchFamily="2" charset="2"/>
              </a:rPr>
              <a:t>) = co-localized staining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(F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There were no changes in Iba1 cell proliferation (counts/mm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of Iba1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Ki67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)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at E11.5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(G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MFI of Ki67 using the same sections also revealed no differences between treatments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Similar to the earlier time point, there were no differences in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(H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Iba1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cell proliferation or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(I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Ki67 MFI at E16.5.</a:t>
            </a:r>
            <a:r>
              <a:rPr lang="en-US" sz="12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-K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ba1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i67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re not altered in a region-specific manner at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J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 or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K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 dpi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-M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imilarly, there were no changes in brain regions of Ki67 MFI at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L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 or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M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7 dpi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V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nfluenza A virus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p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days post-inoculation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saline control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d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embryonic day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F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mean fluorescence intensity. Groups were compared with one-way ANOVA with Tukey post hoc for multiple comparisons. Data are means ± SEM; # = p &lt; 0.1, ** = p &lt; 0.01; dots represent one representative fetus per litter; n = 9-14 per treatment group. </a:t>
            </a:r>
          </a:p>
          <a:p>
            <a:pPr algn="just"/>
            <a:endParaRPr lang="en-US" sz="1200" b="1" dirty="0">
              <a:solidFill>
                <a:srgbClr val="FF0000"/>
              </a:solidFill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47503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4D674B9-7696-8137-14CA-73CB48D8F665}"/>
              </a:ext>
            </a:extLst>
          </p:cNvPr>
          <p:cNvSpPr txBox="1"/>
          <p:nvPr/>
        </p:nvSpPr>
        <p:spPr>
          <a:xfrm>
            <a:off x="-1" y="0"/>
            <a:ext cx="6480175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1. Bulk RNA-sequencing alignment and differential gene expression in E16.5 fetal brains. (A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percentage of reads mapped to the transcriptome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ormalization of samples using the trimmed mean of M values (TMM) method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ltidimensional clustering of the top 5,000 most variable genes after removing the effects of 4 RUV factors. Dimension 1 explains 30.4% of the variation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isualization of differential gene expression showing 211 upregulated genes and 173 downregulated genes when comparing fetal brains from Con and X31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ams (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njamin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Hochberg FDR correction, p &lt; 0.1)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V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nfluenza A virus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embryonic day,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saline control,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UV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remove unwanted variance,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DR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false discovery rate; n = 4-6 per treatment group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1615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9952939"/>
              </p:ext>
            </p:extLst>
          </p:nvPr>
        </p:nvGraphicFramePr>
        <p:xfrm>
          <a:off x="66675" y="327739"/>
          <a:ext cx="3470275" cy="19351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7284465" imgH="4061817" progId="Prism9.Document">
                  <p:embed/>
                </p:oleObj>
              </mc:Choice>
              <mc:Fallback>
                <p:oleObj name="Prism 9" r:id="rId2" imgW="7284465" imgH="406181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6675" y="327739"/>
                        <a:ext cx="3470275" cy="19351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8591516"/>
              </p:ext>
            </p:extLst>
          </p:nvPr>
        </p:nvGraphicFramePr>
        <p:xfrm>
          <a:off x="3230563" y="327739"/>
          <a:ext cx="3017837" cy="20480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6362158" imgH="4317887" progId="Prism9.Document">
                  <p:embed/>
                </p:oleObj>
              </mc:Choice>
              <mc:Fallback>
                <p:oleObj name="Prism 9" r:id="rId4" imgW="6362158" imgH="431788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30563" y="327739"/>
                        <a:ext cx="3017837" cy="20480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449590" y="154801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Maternal Body Weight</a:t>
            </a:r>
          </a:p>
          <a:p>
            <a:pPr algn="ctr"/>
            <a:endParaRPr lang="en-US" sz="9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D674B9-7696-8137-14CA-73CB48D8F665}"/>
              </a:ext>
            </a:extLst>
          </p:cNvPr>
          <p:cNvSpPr txBox="1"/>
          <p:nvPr/>
        </p:nvSpPr>
        <p:spPr>
          <a:xfrm>
            <a:off x="0" y="2375772"/>
            <a:ext cx="63373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2. Maternal body weight at 2 and 7 dpi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tern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 body weight was significantly different between control and IAV-X31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ams starting at GD15.5, 6 dpi (repeated measures two-way ANOVA, the main effect of time = p &lt; 0.001; * = Con vs X31</a:t>
            </a:r>
            <a:r>
              <a:rPr lang="en-US" sz="12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V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nfluenza A virus,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pi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days post-inoculation,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saline control,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d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,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n = 9-14 per treatment group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4532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/>
          <p:cNvGrpSpPr/>
          <p:nvPr/>
        </p:nvGrpSpPr>
        <p:grpSpPr>
          <a:xfrm>
            <a:off x="2887663" y="1521778"/>
            <a:ext cx="3541395" cy="1282382"/>
            <a:chOff x="2887663" y="1521778"/>
            <a:chExt cx="3541395" cy="1282382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87202398"/>
                </p:ext>
              </p:extLst>
            </p:nvPr>
          </p:nvGraphicFramePr>
          <p:xfrm>
            <a:off x="3919220" y="1521778"/>
            <a:ext cx="936625" cy="12747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2847953" imgH="3875618" progId="Prism9.Document">
                    <p:embed/>
                  </p:oleObj>
                </mc:Choice>
                <mc:Fallback>
                  <p:oleObj name="Prism 9" r:id="rId3" imgW="2847953" imgH="3875618" progId="Prism9.Document">
                    <p:embed/>
                    <p:pic>
                      <p:nvPicPr>
                        <p:cNvPr id="4" name="Object 3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919220" y="1521778"/>
                          <a:ext cx="936625" cy="12747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/>
            <p:cNvGraphicFramePr>
              <a:graphicFrameLocks noChangeAspect="1"/>
            </p:cNvGraphicFramePr>
            <p:nvPr/>
          </p:nvGraphicFramePr>
          <p:xfrm>
            <a:off x="5492433" y="1535748"/>
            <a:ext cx="936625" cy="12684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2847953" imgH="3854369" progId="Prism9.Document">
                    <p:embed/>
                  </p:oleObj>
                </mc:Choice>
                <mc:Fallback>
                  <p:oleObj name="Prism 9" r:id="rId5" imgW="2847953" imgH="3854369" progId="Prism9.Document">
                    <p:embed/>
                    <p:pic>
                      <p:nvPicPr>
                        <p:cNvPr id="6" name="Object 5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492433" y="1535748"/>
                          <a:ext cx="936625" cy="12684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10207795"/>
                </p:ext>
              </p:extLst>
            </p:nvPr>
          </p:nvGraphicFramePr>
          <p:xfrm>
            <a:off x="2887663" y="1527175"/>
            <a:ext cx="1135062" cy="12747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3467027" imgH="3881740" progId="Prism9.Document">
                    <p:embed/>
                  </p:oleObj>
                </mc:Choice>
                <mc:Fallback>
                  <p:oleObj name="Prism 9" r:id="rId7" imgW="3467027" imgH="3881740" progId="Prism9.Document">
                    <p:embed/>
                    <p:pic>
                      <p:nvPicPr>
                        <p:cNvPr id="10" name="Object 9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887663" y="1527175"/>
                          <a:ext cx="1135062" cy="12747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Object 14"/>
            <p:cNvGraphicFramePr>
              <a:graphicFrameLocks noChangeAspect="1"/>
            </p:cNvGraphicFramePr>
            <p:nvPr/>
          </p:nvGraphicFramePr>
          <p:xfrm>
            <a:off x="4715193" y="1553210"/>
            <a:ext cx="938212" cy="1247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2847953" imgH="3790261" progId="Prism9.Document">
                    <p:embed/>
                  </p:oleObj>
                </mc:Choice>
                <mc:Fallback>
                  <p:oleObj name="Prism 9" r:id="rId9" imgW="2847953" imgH="3790261" progId="Prism9.Document">
                    <p:embed/>
                    <p:pic>
                      <p:nvPicPr>
                        <p:cNvPr id="15" name="Object 14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715193" y="1553210"/>
                          <a:ext cx="938212" cy="1247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49" name="Group 48"/>
          <p:cNvGrpSpPr/>
          <p:nvPr/>
        </p:nvGrpSpPr>
        <p:grpSpPr>
          <a:xfrm>
            <a:off x="0" y="4237837"/>
            <a:ext cx="6297613" cy="1281113"/>
            <a:chOff x="0" y="3940175"/>
            <a:chExt cx="6297613" cy="1281113"/>
          </a:xfrm>
        </p:grpSpPr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85556816"/>
                </p:ext>
              </p:extLst>
            </p:nvPr>
          </p:nvGraphicFramePr>
          <p:xfrm>
            <a:off x="0" y="3965575"/>
            <a:ext cx="1074738" cy="1247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3265711" imgH="3790261" progId="Prism9.Document">
                    <p:embed/>
                  </p:oleObj>
                </mc:Choice>
                <mc:Fallback>
                  <p:oleObj name="Prism 9" r:id="rId11" imgW="3265711" imgH="3790261" progId="Prism9.Document">
                    <p:embed/>
                    <p:pic>
                      <p:nvPicPr>
                        <p:cNvPr id="5" name="Object 4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0" y="3965575"/>
                          <a:ext cx="1074738" cy="1247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/>
          </p:nvGraphicFramePr>
          <p:xfrm>
            <a:off x="3679825" y="3973513"/>
            <a:ext cx="890588" cy="1247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2706060" imgH="3790261" progId="Prism9.Document">
                    <p:embed/>
                  </p:oleObj>
                </mc:Choice>
                <mc:Fallback>
                  <p:oleObj name="Prism 9" r:id="rId13" imgW="2706060" imgH="3790261" progId="Prism9.Document">
                    <p:embed/>
                    <p:pic>
                      <p:nvPicPr>
                        <p:cNvPr id="7" name="Object 6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679825" y="3973513"/>
                          <a:ext cx="890588" cy="1247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/>
            <p:cNvGraphicFramePr>
              <a:graphicFrameLocks noChangeAspect="1"/>
            </p:cNvGraphicFramePr>
            <p:nvPr/>
          </p:nvGraphicFramePr>
          <p:xfrm>
            <a:off x="4567238" y="3973513"/>
            <a:ext cx="890587" cy="1247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2706060" imgH="3790261" progId="Prism9.Document">
                    <p:embed/>
                  </p:oleObj>
                </mc:Choice>
                <mc:Fallback>
                  <p:oleObj name="Prism 9" r:id="rId15" imgW="2706060" imgH="3790261" progId="Prism9.Document">
                    <p:embed/>
                    <p:pic>
                      <p:nvPicPr>
                        <p:cNvPr id="8" name="Object 7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4567238" y="3973513"/>
                          <a:ext cx="890587" cy="1247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/>
            <p:cNvGraphicFramePr>
              <a:graphicFrameLocks noChangeAspect="1"/>
            </p:cNvGraphicFramePr>
            <p:nvPr/>
          </p:nvGraphicFramePr>
          <p:xfrm>
            <a:off x="1001713" y="3973513"/>
            <a:ext cx="892175" cy="1247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7" imgW="2706060" imgH="3790261" progId="Prism9.Document">
                    <p:embed/>
                  </p:oleObj>
                </mc:Choice>
                <mc:Fallback>
                  <p:oleObj name="Prism 9" r:id="rId17" imgW="2706060" imgH="3790261" progId="Prism9.Document">
                    <p:embed/>
                    <p:pic>
                      <p:nvPicPr>
                        <p:cNvPr id="9" name="Object 8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001713" y="3973513"/>
                          <a:ext cx="892175" cy="1247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/>
            <p:cNvGraphicFramePr>
              <a:graphicFrameLocks noChangeAspect="1"/>
            </p:cNvGraphicFramePr>
            <p:nvPr/>
          </p:nvGraphicFramePr>
          <p:xfrm>
            <a:off x="1851025" y="3940175"/>
            <a:ext cx="842963" cy="1277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9" imgW="2564166" imgH="3881740" progId="Prism9.Document">
                    <p:embed/>
                  </p:oleObj>
                </mc:Choice>
                <mc:Fallback>
                  <p:oleObj name="Prism 9" r:id="rId19" imgW="2564166" imgH="3881740" progId="Prism9.Document">
                    <p:embed/>
                    <p:pic>
                      <p:nvPicPr>
                        <p:cNvPr id="11" name="Object 10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1851025" y="3940175"/>
                          <a:ext cx="842963" cy="12779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ct 12"/>
            <p:cNvGraphicFramePr>
              <a:graphicFrameLocks noChangeAspect="1"/>
            </p:cNvGraphicFramePr>
            <p:nvPr/>
          </p:nvGraphicFramePr>
          <p:xfrm>
            <a:off x="2697163" y="3973513"/>
            <a:ext cx="936625" cy="1247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1" imgW="2847953" imgH="3790261" progId="Prism9.Document">
                    <p:embed/>
                  </p:oleObj>
                </mc:Choice>
                <mc:Fallback>
                  <p:oleObj name="Prism 9" r:id="rId21" imgW="2847953" imgH="3790261" progId="Prism9.Document">
                    <p:embed/>
                    <p:pic>
                      <p:nvPicPr>
                        <p:cNvPr id="13" name="Object 12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2697163" y="3973513"/>
                          <a:ext cx="936625" cy="1247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Object 15"/>
            <p:cNvGraphicFramePr>
              <a:graphicFrameLocks noChangeAspect="1"/>
            </p:cNvGraphicFramePr>
            <p:nvPr/>
          </p:nvGraphicFramePr>
          <p:xfrm>
            <a:off x="5407025" y="3973513"/>
            <a:ext cx="890588" cy="1247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3" imgW="2706060" imgH="3790261" progId="Prism9.Document">
                    <p:embed/>
                  </p:oleObj>
                </mc:Choice>
                <mc:Fallback>
                  <p:oleObj name="Prism 9" r:id="rId23" imgW="2706060" imgH="3790261" progId="Prism9.Document">
                    <p:embed/>
                    <p:pic>
                      <p:nvPicPr>
                        <p:cNvPr id="16" name="Object 15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5407025" y="3973513"/>
                          <a:ext cx="890588" cy="1247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48" name="Group 47"/>
          <p:cNvGrpSpPr/>
          <p:nvPr/>
        </p:nvGrpSpPr>
        <p:grpSpPr>
          <a:xfrm>
            <a:off x="12700" y="2870919"/>
            <a:ext cx="6293456" cy="1379101"/>
            <a:chOff x="12700" y="2656471"/>
            <a:chExt cx="6293456" cy="1379101"/>
          </a:xfrm>
        </p:grpSpPr>
        <p:graphicFrame>
          <p:nvGraphicFramePr>
            <p:cNvPr id="18" name="Object 17"/>
            <p:cNvGraphicFramePr>
              <a:graphicFrameLocks noChangeAspect="1"/>
            </p:cNvGraphicFramePr>
            <p:nvPr/>
          </p:nvGraphicFramePr>
          <p:xfrm>
            <a:off x="3681374" y="2661279"/>
            <a:ext cx="892517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5" imgW="2706060" imgH="4157618" progId="Prism9.Document">
                    <p:embed/>
                  </p:oleObj>
                </mc:Choice>
                <mc:Fallback>
                  <p:oleObj name="Prism 9" r:id="rId25" imgW="2706060" imgH="4157618" progId="Prism9.Document">
                    <p:embed/>
                    <p:pic>
                      <p:nvPicPr>
                        <p:cNvPr id="18" name="Object 17"/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3681374" y="2661279"/>
                          <a:ext cx="892517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Object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4425242"/>
                </p:ext>
              </p:extLst>
            </p:nvPr>
          </p:nvGraphicFramePr>
          <p:xfrm>
            <a:off x="957919" y="2656471"/>
            <a:ext cx="1143888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7" imgW="3480712" imgH="4169863" progId="Prism9.Document">
                    <p:embed/>
                  </p:oleObj>
                </mc:Choice>
                <mc:Fallback>
                  <p:oleObj name="Prism 9" r:id="rId27" imgW="3480712" imgH="4169863" progId="Prism9.Document">
                    <p:embed/>
                    <p:pic>
                      <p:nvPicPr>
                        <p:cNvPr id="20" name="Object 19"/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957919" y="2656471"/>
                          <a:ext cx="1143888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Object 20"/>
            <p:cNvGraphicFramePr>
              <a:graphicFrameLocks noChangeAspect="1"/>
            </p:cNvGraphicFramePr>
            <p:nvPr/>
          </p:nvGraphicFramePr>
          <p:xfrm>
            <a:off x="12700" y="2660650"/>
            <a:ext cx="1066800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9" imgW="3238340" imgH="4157618" progId="Prism9.Document">
                    <p:embed/>
                  </p:oleObj>
                </mc:Choice>
                <mc:Fallback>
                  <p:oleObj name="Prism 9" r:id="rId29" imgW="3238340" imgH="4157618" progId="Prism9.Document">
                    <p:embed/>
                    <p:pic>
                      <p:nvPicPr>
                        <p:cNvPr id="21" name="Object 20"/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12700" y="2660650"/>
                          <a:ext cx="1066800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Object 24"/>
            <p:cNvGraphicFramePr>
              <a:graphicFrameLocks noChangeAspect="1"/>
            </p:cNvGraphicFramePr>
            <p:nvPr/>
          </p:nvGraphicFramePr>
          <p:xfrm>
            <a:off x="1846715" y="2659028"/>
            <a:ext cx="845289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1" imgW="2564166" imgH="4157618" progId="Prism9.Document">
                    <p:embed/>
                  </p:oleObj>
                </mc:Choice>
                <mc:Fallback>
                  <p:oleObj name="Prism 9" r:id="rId31" imgW="2564166" imgH="4157618" progId="Prism9.Document">
                    <p:embed/>
                    <p:pic>
                      <p:nvPicPr>
                        <p:cNvPr id="25" name="Object 24"/>
                        <p:cNvPicPr/>
                        <p:nvPr/>
                      </p:nvPicPr>
                      <p:blipFill>
                        <a:blip r:embed="rId32"/>
                        <a:stretch>
                          <a:fillRect/>
                        </a:stretch>
                      </p:blipFill>
                      <p:spPr>
                        <a:xfrm>
                          <a:off x="1846715" y="2659028"/>
                          <a:ext cx="845289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/>
            <p:cNvGraphicFramePr>
              <a:graphicFrameLocks noChangeAspect="1"/>
            </p:cNvGraphicFramePr>
            <p:nvPr/>
          </p:nvGraphicFramePr>
          <p:xfrm>
            <a:off x="5459775" y="2659404"/>
            <a:ext cx="846381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3" imgW="2564166" imgH="4157618" progId="Prism9.Document">
                    <p:embed/>
                  </p:oleObj>
                </mc:Choice>
                <mc:Fallback>
                  <p:oleObj name="Prism 9" r:id="rId33" imgW="2564166" imgH="4157618" progId="Prism9.Document">
                    <p:embed/>
                    <p:pic>
                      <p:nvPicPr>
                        <p:cNvPr id="26" name="Object 25"/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5459775" y="2659404"/>
                          <a:ext cx="846381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ct 26"/>
            <p:cNvGraphicFramePr>
              <a:graphicFrameLocks noChangeAspect="1"/>
            </p:cNvGraphicFramePr>
            <p:nvPr/>
          </p:nvGraphicFramePr>
          <p:xfrm>
            <a:off x="4617131" y="2661279"/>
            <a:ext cx="844607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5" imgW="2564166" imgH="4157618" progId="Prism9.Document">
                    <p:embed/>
                  </p:oleObj>
                </mc:Choice>
                <mc:Fallback>
                  <p:oleObj name="Prism 9" r:id="rId35" imgW="2564166" imgH="4157618" progId="Prism9.Document">
                    <p:embed/>
                    <p:pic>
                      <p:nvPicPr>
                        <p:cNvPr id="27" name="Object 26"/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4617131" y="2661279"/>
                          <a:ext cx="844607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7056345"/>
                </p:ext>
              </p:extLst>
            </p:nvPr>
          </p:nvGraphicFramePr>
          <p:xfrm>
            <a:off x="2691363" y="2663972"/>
            <a:ext cx="952303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7" imgW="2847953" imgH="4093871" progId="Prism9.Document">
                    <p:embed/>
                  </p:oleObj>
                </mc:Choice>
                <mc:Fallback>
                  <p:oleObj name="Prism 9" r:id="rId37" imgW="2847953" imgH="4093871" progId="Prism9.Document">
                    <p:embed/>
                    <p:pic>
                      <p:nvPicPr>
                        <p:cNvPr id="28" name="Object 27"/>
                        <p:cNvPicPr/>
                        <p:nvPr/>
                      </p:nvPicPr>
                      <p:blipFill>
                        <a:blip r:embed="rId38"/>
                        <a:stretch>
                          <a:fillRect/>
                        </a:stretch>
                      </p:blipFill>
                      <p:spPr>
                        <a:xfrm>
                          <a:off x="2691363" y="2663972"/>
                          <a:ext cx="952303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44" name="Group 43"/>
          <p:cNvGrpSpPr/>
          <p:nvPr/>
        </p:nvGrpSpPr>
        <p:grpSpPr>
          <a:xfrm>
            <a:off x="2903538" y="225425"/>
            <a:ext cx="3508064" cy="1379317"/>
            <a:chOff x="2903538" y="309245"/>
            <a:chExt cx="3508064" cy="1379317"/>
          </a:xfrm>
        </p:grpSpPr>
        <p:graphicFrame>
          <p:nvGraphicFramePr>
            <p:cNvPr id="19" name="Object 1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76459128"/>
                </p:ext>
              </p:extLst>
            </p:nvPr>
          </p:nvGraphicFramePr>
          <p:xfrm>
            <a:off x="5565221" y="310289"/>
            <a:ext cx="846381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9" imgW="2564166" imgH="4157618" progId="Prism9.Document">
                    <p:embed/>
                  </p:oleObj>
                </mc:Choice>
                <mc:Fallback>
                  <p:oleObj name="Prism 9" r:id="rId39" imgW="2564166" imgH="4157618" progId="Prism9.Document">
                    <p:embed/>
                    <p:pic>
                      <p:nvPicPr>
                        <p:cNvPr id="19" name="Object 18"/>
                        <p:cNvPicPr/>
                        <p:nvPr/>
                      </p:nvPicPr>
                      <p:blipFill>
                        <a:blip r:embed="rId40"/>
                        <a:stretch>
                          <a:fillRect/>
                        </a:stretch>
                      </p:blipFill>
                      <p:spPr>
                        <a:xfrm>
                          <a:off x="5565221" y="310289"/>
                          <a:ext cx="846381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Object 21"/>
            <p:cNvGraphicFramePr>
              <a:graphicFrameLocks noChangeAspect="1"/>
            </p:cNvGraphicFramePr>
            <p:nvPr/>
          </p:nvGraphicFramePr>
          <p:xfrm>
            <a:off x="4723001" y="309342"/>
            <a:ext cx="892516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1" imgW="2706060" imgH="4157618" progId="Prism9.Document">
                    <p:embed/>
                  </p:oleObj>
                </mc:Choice>
                <mc:Fallback>
                  <p:oleObj name="Prism 9" r:id="rId41" imgW="2706060" imgH="4157618" progId="Prism9.Document">
                    <p:embed/>
                    <p:pic>
                      <p:nvPicPr>
                        <p:cNvPr id="22" name="Object 21"/>
                        <p:cNvPicPr/>
                        <p:nvPr/>
                      </p:nvPicPr>
                      <p:blipFill>
                        <a:blip r:embed="rId42"/>
                        <a:stretch>
                          <a:fillRect/>
                        </a:stretch>
                      </p:blipFill>
                      <p:spPr>
                        <a:xfrm>
                          <a:off x="4723001" y="309342"/>
                          <a:ext cx="892516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Object 2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43463042"/>
                </p:ext>
              </p:extLst>
            </p:nvPr>
          </p:nvGraphicFramePr>
          <p:xfrm>
            <a:off x="2903538" y="309245"/>
            <a:ext cx="1116012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3" imgW="3384555" imgH="4157618" progId="Prism9.Document">
                    <p:embed/>
                  </p:oleObj>
                </mc:Choice>
                <mc:Fallback>
                  <p:oleObj name="Prism 9" r:id="rId43" imgW="3384555" imgH="4157618" progId="Prism9.Document">
                    <p:embed/>
                    <p:pic>
                      <p:nvPicPr>
                        <p:cNvPr id="24" name="Object 23"/>
                        <p:cNvPicPr/>
                        <p:nvPr/>
                      </p:nvPicPr>
                      <p:blipFill>
                        <a:blip r:embed="rId44"/>
                        <a:stretch>
                          <a:fillRect/>
                        </a:stretch>
                      </p:blipFill>
                      <p:spPr>
                        <a:xfrm>
                          <a:off x="2903538" y="309245"/>
                          <a:ext cx="1116012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bject 28"/>
            <p:cNvGraphicFramePr>
              <a:graphicFrameLocks noChangeAspect="1"/>
            </p:cNvGraphicFramePr>
            <p:nvPr/>
          </p:nvGraphicFramePr>
          <p:xfrm>
            <a:off x="3918749" y="316962"/>
            <a:ext cx="954080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5" imgW="2847953" imgH="4093871" progId="Prism9.Document">
                    <p:embed/>
                  </p:oleObj>
                </mc:Choice>
                <mc:Fallback>
                  <p:oleObj name="Prism 9" r:id="rId45" imgW="2847953" imgH="4093871" progId="Prism9.Document">
                    <p:embed/>
                    <p:pic>
                      <p:nvPicPr>
                        <p:cNvPr id="29" name="Object 28"/>
                        <p:cNvPicPr/>
                        <p:nvPr/>
                      </p:nvPicPr>
                      <p:blipFill>
                        <a:blip r:embed="rId46"/>
                        <a:stretch>
                          <a:fillRect/>
                        </a:stretch>
                      </p:blipFill>
                      <p:spPr>
                        <a:xfrm>
                          <a:off x="3918749" y="316962"/>
                          <a:ext cx="954080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0" name="Group 29"/>
          <p:cNvGrpSpPr/>
          <p:nvPr/>
        </p:nvGrpSpPr>
        <p:grpSpPr>
          <a:xfrm>
            <a:off x="-6452" y="216872"/>
            <a:ext cx="2949501" cy="1381133"/>
            <a:chOff x="599371" y="4584915"/>
            <a:chExt cx="2949501" cy="1381133"/>
          </a:xfrm>
        </p:grpSpPr>
        <p:graphicFrame>
          <p:nvGraphicFramePr>
            <p:cNvPr id="31" name="Object 30">
              <a:extLst>
                <a:ext uri="{FF2B5EF4-FFF2-40B4-BE49-F238E27FC236}">
                  <a16:creationId xmlns:a16="http://schemas.microsoft.com/office/drawing/2014/main" id="{1B6383F4-874D-BA5C-8C08-AA5DB4333A5C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661904" y="4594447"/>
            <a:ext cx="886968" cy="13716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7" imgW="2424073" imgH="4185350" progId="Prism9.Document">
                    <p:embed/>
                  </p:oleObj>
                </mc:Choice>
                <mc:Fallback>
                  <p:oleObj name="Prism 9" r:id="rId47" imgW="2424073" imgH="4185350" progId="Prism9.Document">
                    <p:embed/>
                    <p:pic>
                      <p:nvPicPr>
                        <p:cNvPr id="31" name="Object 30">
                          <a:extLst>
                            <a:ext uri="{FF2B5EF4-FFF2-40B4-BE49-F238E27FC236}">
                              <a16:creationId xmlns:a16="http://schemas.microsoft.com/office/drawing/2014/main" id="{1B6383F4-874D-BA5C-8C08-AA5DB4333A5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8"/>
                        <a:stretch>
                          <a:fillRect/>
                        </a:stretch>
                      </p:blipFill>
                      <p:spPr>
                        <a:xfrm>
                          <a:off x="2661904" y="4594447"/>
                          <a:ext cx="886968" cy="13716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2" name="Object 31"/>
            <p:cNvGraphicFramePr>
              <a:graphicFrameLocks/>
            </p:cNvGraphicFramePr>
            <p:nvPr/>
          </p:nvGraphicFramePr>
          <p:xfrm>
            <a:off x="599371" y="4593707"/>
            <a:ext cx="1106424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9" imgW="3101129" imgH="4157618" progId="Prism9.Document">
                    <p:embed/>
                  </p:oleObj>
                </mc:Choice>
                <mc:Fallback>
                  <p:oleObj name="Prism 9" r:id="rId49" imgW="3101129" imgH="4157618" progId="Prism9.Document">
                    <p:embed/>
                    <p:pic>
                      <p:nvPicPr>
                        <p:cNvPr id="32" name="Object 31"/>
                        <p:cNvPicPr/>
                        <p:nvPr/>
                      </p:nvPicPr>
                      <p:blipFill>
                        <a:blip r:embed="rId50"/>
                        <a:stretch>
                          <a:fillRect/>
                        </a:stretch>
                      </p:blipFill>
                      <p:spPr>
                        <a:xfrm>
                          <a:off x="599371" y="4593707"/>
                          <a:ext cx="1106424" cy="1371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3" name="Object 3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58914688"/>
                </p:ext>
              </p:extLst>
            </p:nvPr>
          </p:nvGraphicFramePr>
          <p:xfrm>
            <a:off x="1749443" y="4584915"/>
            <a:ext cx="886968" cy="13716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1" imgW="2424073" imgH="4194354" progId="Prism9.Document">
                    <p:embed/>
                  </p:oleObj>
                </mc:Choice>
                <mc:Fallback>
                  <p:oleObj name="Prism 9" r:id="rId51" imgW="2424073" imgH="4194354" progId="Prism9.Document">
                    <p:embed/>
                    <p:pic>
                      <p:nvPicPr>
                        <p:cNvPr id="33" name="Object 32"/>
                        <p:cNvPicPr/>
                        <p:nvPr/>
                      </p:nvPicPr>
                      <p:blipFill>
                        <a:blip r:embed="rId52"/>
                        <a:stretch>
                          <a:fillRect/>
                        </a:stretch>
                      </p:blipFill>
                      <p:spPr>
                        <a:xfrm>
                          <a:off x="1749443" y="4584915"/>
                          <a:ext cx="886968" cy="13716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C0FF1097-3CFE-35FD-DF31-FE4C7199D70D}"/>
              </a:ext>
            </a:extLst>
          </p:cNvPr>
          <p:cNvSpPr txBox="1"/>
          <p:nvPr/>
        </p:nvSpPr>
        <p:spPr>
          <a:xfrm>
            <a:off x="930842" y="102006"/>
            <a:ext cx="141617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Lung Antiviral Cytokines</a:t>
            </a:r>
          </a:p>
        </p:txBody>
      </p:sp>
      <p:grpSp>
        <p:nvGrpSpPr>
          <p:cNvPr id="35" name="Group 34"/>
          <p:cNvGrpSpPr/>
          <p:nvPr/>
        </p:nvGrpSpPr>
        <p:grpSpPr>
          <a:xfrm>
            <a:off x="-25400" y="1521778"/>
            <a:ext cx="2970212" cy="1281113"/>
            <a:chOff x="3053102" y="5509142"/>
            <a:chExt cx="4007698" cy="1728601"/>
          </a:xfrm>
        </p:grpSpPr>
        <p:graphicFrame>
          <p:nvGraphicFramePr>
            <p:cNvPr id="36" name="Object 35">
              <a:extLst>
                <a:ext uri="{FF2B5EF4-FFF2-40B4-BE49-F238E27FC236}">
                  <a16:creationId xmlns:a16="http://schemas.microsoft.com/office/drawing/2014/main" id="{AB88C6F6-59E6-D49D-E229-5660E9867874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863417" y="5515568"/>
            <a:ext cx="1197383" cy="1722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3" imgW="2424073" imgH="3854369" progId="Prism9.Document">
                    <p:embed/>
                  </p:oleObj>
                </mc:Choice>
                <mc:Fallback>
                  <p:oleObj name="Prism 9" r:id="rId53" imgW="2424073" imgH="3854369" progId="Prism9.Document">
                    <p:embed/>
                    <p:pic>
                      <p:nvPicPr>
                        <p:cNvPr id="36" name="Object 35">
                          <a:extLst>
                            <a:ext uri="{FF2B5EF4-FFF2-40B4-BE49-F238E27FC236}">
                              <a16:creationId xmlns:a16="http://schemas.microsoft.com/office/drawing/2014/main" id="{AB88C6F6-59E6-D49D-E229-5660E986787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4"/>
                        <a:stretch>
                          <a:fillRect/>
                        </a:stretch>
                      </p:blipFill>
                      <p:spPr>
                        <a:xfrm>
                          <a:off x="5863417" y="5515568"/>
                          <a:ext cx="1197383" cy="1722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7" name="Object 36"/>
            <p:cNvGraphicFramePr>
              <a:graphicFrameLocks/>
            </p:cNvGraphicFramePr>
            <p:nvPr/>
          </p:nvGraphicFramePr>
          <p:xfrm>
            <a:off x="4627479" y="5517710"/>
            <a:ext cx="1197382" cy="17200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5" imgW="2424073" imgH="3868054" progId="Prism9.Document">
                    <p:embed/>
                  </p:oleObj>
                </mc:Choice>
                <mc:Fallback>
                  <p:oleObj name="Prism 9" r:id="rId55" imgW="2424073" imgH="3868054" progId="Prism9.Document">
                    <p:embed/>
                    <p:pic>
                      <p:nvPicPr>
                        <p:cNvPr id="37" name="Object 36"/>
                        <p:cNvPicPr/>
                        <p:nvPr/>
                      </p:nvPicPr>
                      <p:blipFill>
                        <a:blip r:embed="rId56"/>
                        <a:stretch>
                          <a:fillRect/>
                        </a:stretch>
                      </p:blipFill>
                      <p:spPr>
                        <a:xfrm>
                          <a:off x="4627479" y="5517710"/>
                          <a:ext cx="1197382" cy="17200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8" name="Object 37"/>
            <p:cNvGraphicFramePr>
              <a:graphicFrameLocks/>
            </p:cNvGraphicFramePr>
            <p:nvPr/>
          </p:nvGraphicFramePr>
          <p:xfrm>
            <a:off x="3053102" y="5509142"/>
            <a:ext cx="1492981" cy="172645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7" imgW="3128499" imgH="3854369" progId="Prism9.Document">
                    <p:embed/>
                  </p:oleObj>
                </mc:Choice>
                <mc:Fallback>
                  <p:oleObj name="Prism 9" r:id="rId57" imgW="3128499" imgH="3854369" progId="Prism9.Document">
                    <p:embed/>
                    <p:pic>
                      <p:nvPicPr>
                        <p:cNvPr id="38" name="Object 37"/>
                        <p:cNvPicPr/>
                        <p:nvPr/>
                      </p:nvPicPr>
                      <p:blipFill>
                        <a:blip r:embed="rId58"/>
                        <a:stretch>
                          <a:fillRect/>
                        </a:stretch>
                      </p:blipFill>
                      <p:spPr>
                        <a:xfrm>
                          <a:off x="3053102" y="5509142"/>
                          <a:ext cx="1492981" cy="172645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C0FF1097-3CFE-35FD-DF31-FE4C7199D70D}"/>
              </a:ext>
            </a:extLst>
          </p:cNvPr>
          <p:cNvSpPr txBox="1"/>
          <p:nvPr/>
        </p:nvSpPr>
        <p:spPr>
          <a:xfrm>
            <a:off x="4076259" y="102239"/>
            <a:ext cx="141617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irculating Cytokine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0FF1097-3CFE-35FD-DF31-FE4C7199D70D}"/>
              </a:ext>
            </a:extLst>
          </p:cNvPr>
          <p:cNvSpPr txBox="1"/>
          <p:nvPr/>
        </p:nvSpPr>
        <p:spPr>
          <a:xfrm>
            <a:off x="2442760" y="2756643"/>
            <a:ext cx="141617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irculating Cytokines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-79795" y="71939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2850956" y="69139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-234383" y="2720923"/>
            <a:ext cx="8157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51515D4-3F9A-2EC4-9A7C-0045127491D3}"/>
              </a:ext>
            </a:extLst>
          </p:cNvPr>
          <p:cNvSpPr txBox="1"/>
          <p:nvPr/>
        </p:nvSpPr>
        <p:spPr>
          <a:xfrm>
            <a:off x="-83217" y="1415097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58F2211-953F-A287-7778-B36F85E4D5A3}"/>
              </a:ext>
            </a:extLst>
          </p:cNvPr>
          <p:cNvSpPr txBox="1"/>
          <p:nvPr/>
        </p:nvSpPr>
        <p:spPr>
          <a:xfrm>
            <a:off x="2849996" y="1414115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0FD93B4-BA65-315B-E3F7-98640AB53D00}"/>
              </a:ext>
            </a:extLst>
          </p:cNvPr>
          <p:cNvSpPr txBox="1"/>
          <p:nvPr/>
        </p:nvSpPr>
        <p:spPr>
          <a:xfrm>
            <a:off x="-236324" y="4130807"/>
            <a:ext cx="8157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75" name="Group 74">
            <a:extLst>
              <a:ext uri="{FF2B5EF4-FFF2-40B4-BE49-F238E27FC236}">
                <a16:creationId xmlns:a16="http://schemas.microsoft.com/office/drawing/2014/main" id="{3DA8F97E-9C28-BF15-A936-58342D1D2223}"/>
              </a:ext>
            </a:extLst>
          </p:cNvPr>
          <p:cNvGrpSpPr/>
          <p:nvPr/>
        </p:nvGrpSpPr>
        <p:grpSpPr>
          <a:xfrm>
            <a:off x="437853" y="5451205"/>
            <a:ext cx="2004809" cy="202923"/>
            <a:chOff x="1506483" y="7822115"/>
            <a:chExt cx="2705087" cy="273806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2ACD7942-8D0F-106D-0064-AC746F44ED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06483" y="7822115"/>
              <a:ext cx="2705087" cy="273806"/>
              <a:chOff x="2376664" y="4624110"/>
              <a:chExt cx="2654130" cy="268646"/>
            </a:xfrm>
          </p:grpSpPr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AF1BBFB5-F136-74A5-EC62-385A26239619}"/>
                  </a:ext>
                </a:extLst>
              </p:cNvPr>
              <p:cNvSpPr txBox="1"/>
              <p:nvPr/>
            </p:nvSpPr>
            <p:spPr>
              <a:xfrm>
                <a:off x="2376664" y="4624113"/>
                <a:ext cx="985119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 dpi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gend: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3B9872B2-9D1A-EB02-54AB-9FF97973659E}"/>
                  </a:ext>
                </a:extLst>
              </p:cNvPr>
              <p:cNvSpPr txBox="1"/>
              <p:nvPr/>
            </p:nvSpPr>
            <p:spPr>
              <a:xfrm>
                <a:off x="3333982" y="4624111"/>
                <a:ext cx="460938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2B696D2C-658E-0F65-BAA3-0FAA9CA6BEDC}"/>
                  </a:ext>
                </a:extLst>
              </p:cNvPr>
              <p:cNvSpPr txBox="1"/>
              <p:nvPr/>
            </p:nvSpPr>
            <p:spPr>
              <a:xfrm>
                <a:off x="3880066" y="4624110"/>
                <a:ext cx="609490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mod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9AB4959C-3B6C-CA70-04B7-A0075AB99D90}"/>
                  </a:ext>
                </a:extLst>
              </p:cNvPr>
              <p:cNvSpPr txBox="1"/>
              <p:nvPr/>
            </p:nvSpPr>
            <p:spPr>
              <a:xfrm>
                <a:off x="4514678" y="4624111"/>
                <a:ext cx="516116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</p:txBody>
          </p:sp>
          <p:sp>
            <p:nvSpPr>
              <p:cNvPr id="84" name="Rectangle 83">
                <a:extLst>
                  <a:ext uri="{FF2B5EF4-FFF2-40B4-BE49-F238E27FC236}">
                    <a16:creationId xmlns:a16="http://schemas.microsoft.com/office/drawing/2014/main" id="{7A2596D0-46BE-4279-A5B3-59C91930BE6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456454" y="4628884"/>
                <a:ext cx="2542170" cy="2638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2448212" y="7912323"/>
              <a:ext cx="93196" cy="93196"/>
            </a:xfrm>
            <a:prstGeom prst="rect">
              <a:avLst/>
            </a:prstGeom>
            <a:solidFill>
              <a:srgbClr val="AFAF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3005169" y="7912323"/>
              <a:ext cx="93196" cy="93196"/>
            </a:xfrm>
            <a:prstGeom prst="rect">
              <a:avLst/>
            </a:prstGeom>
            <a:solidFill>
              <a:srgbClr val="21A7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3626556" y="7912323"/>
              <a:ext cx="93196" cy="93196"/>
            </a:xfrm>
            <a:prstGeom prst="rect">
              <a:avLst/>
            </a:prstGeom>
            <a:solidFill>
              <a:srgbClr val="166D74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Group 84">
            <a:extLst>
              <a:ext uri="{FF2B5EF4-FFF2-40B4-BE49-F238E27FC236}">
                <a16:creationId xmlns:a16="http://schemas.microsoft.com/office/drawing/2014/main" id="{3DA8F97E-9C28-BF15-A936-58342D1D2223}"/>
              </a:ext>
            </a:extLst>
          </p:cNvPr>
          <p:cNvGrpSpPr/>
          <p:nvPr/>
        </p:nvGrpSpPr>
        <p:grpSpPr>
          <a:xfrm>
            <a:off x="3989761" y="5450865"/>
            <a:ext cx="2004809" cy="202923"/>
            <a:chOff x="1506483" y="7822115"/>
            <a:chExt cx="2705087" cy="273806"/>
          </a:xfrm>
        </p:grpSpPr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2ACD7942-8D0F-106D-0064-AC746F44ED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06483" y="7822115"/>
              <a:ext cx="2705087" cy="273806"/>
              <a:chOff x="2376664" y="4624110"/>
              <a:chExt cx="2654130" cy="268646"/>
            </a:xfrm>
          </p:grpSpPr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AF1BBFB5-F136-74A5-EC62-385A26239619}"/>
                  </a:ext>
                </a:extLst>
              </p:cNvPr>
              <p:cNvSpPr txBox="1"/>
              <p:nvPr/>
            </p:nvSpPr>
            <p:spPr>
              <a:xfrm>
                <a:off x="2376664" y="4624113"/>
                <a:ext cx="985119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 dpi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gend: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3B9872B2-9D1A-EB02-54AB-9FF97973659E}"/>
                  </a:ext>
                </a:extLst>
              </p:cNvPr>
              <p:cNvSpPr txBox="1"/>
              <p:nvPr/>
            </p:nvSpPr>
            <p:spPr>
              <a:xfrm>
                <a:off x="3333982" y="4624111"/>
                <a:ext cx="460938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2B696D2C-658E-0F65-BAA3-0FAA9CA6BEDC}"/>
                  </a:ext>
                </a:extLst>
              </p:cNvPr>
              <p:cNvSpPr txBox="1"/>
              <p:nvPr/>
            </p:nvSpPr>
            <p:spPr>
              <a:xfrm>
                <a:off x="3880066" y="4624110"/>
                <a:ext cx="609490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mod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9AB4959C-3B6C-CA70-04B7-A0075AB99D90}"/>
                  </a:ext>
                </a:extLst>
              </p:cNvPr>
              <p:cNvSpPr txBox="1"/>
              <p:nvPr/>
            </p:nvSpPr>
            <p:spPr>
              <a:xfrm>
                <a:off x="4514678" y="4624111"/>
                <a:ext cx="516116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</p:txBody>
          </p:sp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7A2596D0-46BE-4279-A5B3-59C91930BE6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456454" y="4628884"/>
                <a:ext cx="2542170" cy="2638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2448212" y="7912323"/>
              <a:ext cx="93196" cy="93196"/>
            </a:xfrm>
            <a:prstGeom prst="rect">
              <a:avLst/>
            </a:prstGeom>
            <a:solidFill>
              <a:srgbClr val="AFAF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3005169" y="7912323"/>
              <a:ext cx="93196" cy="93196"/>
            </a:xfrm>
            <a:prstGeom prst="rect">
              <a:avLst/>
            </a:prstGeom>
            <a:solidFill>
              <a:srgbClr val="BA477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3626556" y="7912323"/>
              <a:ext cx="93196" cy="93196"/>
            </a:xfrm>
            <a:prstGeom prst="rect">
              <a:avLst/>
            </a:prstGeom>
            <a:solidFill>
              <a:srgbClr val="88335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Rectangle 13">
            <a:extLst>
              <a:ext uri="{FF2B5EF4-FFF2-40B4-BE49-F238E27FC236}">
                <a16:creationId xmlns:a16="http://schemas.microsoft.com/office/drawing/2014/main" id="{3B063994-193D-0937-9415-B2A1A74C13DC}"/>
              </a:ext>
            </a:extLst>
          </p:cNvPr>
          <p:cNvSpPr/>
          <p:nvPr/>
        </p:nvSpPr>
        <p:spPr>
          <a:xfrm>
            <a:off x="767741" y="216872"/>
            <a:ext cx="45719" cy="1631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1831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7F8F074-8D1E-7459-AC74-217394F2F8AF}"/>
              </a:ext>
            </a:extLst>
          </p:cNvPr>
          <p:cNvSpPr txBox="1"/>
          <p:nvPr/>
        </p:nvSpPr>
        <p:spPr>
          <a:xfrm>
            <a:off x="0" y="0"/>
            <a:ext cx="6480175" cy="32316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3. Maternal lung interferons and circulating cytokines at 2 and 7 dpi. (A-B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es encoding for antiviral interferons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N</a:t>
            </a:r>
            <a:r>
              <a:rPr lang="en-US" sz="1200" dirty="0" err="1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N</a:t>
            </a:r>
            <a:r>
              <a:rPr lang="en-US" sz="1200" dirty="0" err="1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N</a:t>
            </a:r>
            <a:r>
              <a:rPr lang="en-US" sz="1200" dirty="0" err="1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pregulated or trending towards upregulation in the maternal lung at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 dpi in X31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ams only.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B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7 dpi, there was a significant decline in type I and type II interferons in the IAV-infected maternal lung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-F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 13-plex mouse inflammation panel (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GENDplex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was performed on maternal serum at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, E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 dpi and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, F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7 dpi. Type II antiviral interferon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N</a:t>
            </a:r>
            <a:r>
              <a:rPr lang="en-US" sz="1200" dirty="0" err="1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200" dirty="0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upregulated in a dose-dependent manner at 7 dpi only. IL-23, an inflammatory cytokine and a molecule required for the commitment of pathogenic T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7 cells, was upregulated at 7 dpi. Anti-inflammatory cytokine IL-10 was significantly different amongst treatment groups at 2 dpi and was trending towards upregulation at 7 dpi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V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nfluenza A virus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p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days post-inoculation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saline control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d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Groups were compared with one-way ANOVA with Tukey post hoc for multiple comparisons. For data containing residuals with unequal variance, Brown-Forsythe and Welch’s ANOVA with Dunnett T3 post hoc multiple comparisons was used. For non-parametric data, Kruskal-Wallis ANOVA with Dunn’s correction for multiple comparisons was used. Data are means ± SEM; # = p &lt; 0.1, * = p &lt; 0.05, ** = p &lt; 0.01, *** = p &lt; 0.001; dots represent individual dams; n = 9-14 per treatment group.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56948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 80"/>
          <p:cNvGrpSpPr/>
          <p:nvPr/>
        </p:nvGrpSpPr>
        <p:grpSpPr>
          <a:xfrm>
            <a:off x="3262313" y="3039689"/>
            <a:ext cx="3320304" cy="1273373"/>
            <a:chOff x="3122631" y="4340138"/>
            <a:chExt cx="3320304" cy="1273373"/>
          </a:xfrm>
        </p:grpSpPr>
        <p:graphicFrame>
          <p:nvGraphicFramePr>
            <p:cNvPr id="36" name="Object 3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72977086"/>
                </p:ext>
              </p:extLst>
            </p:nvPr>
          </p:nvGraphicFramePr>
          <p:xfrm>
            <a:off x="3122631" y="4340138"/>
            <a:ext cx="1181100" cy="1271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3939525" imgH="4242975" progId="Prism9.Document">
                    <p:embed/>
                  </p:oleObj>
                </mc:Choice>
                <mc:Fallback>
                  <p:oleObj name="Prism 9" r:id="rId3" imgW="3939525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122631" y="4340138"/>
                          <a:ext cx="1181100" cy="1271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7" name="Object 3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14286941"/>
                </p:ext>
              </p:extLst>
            </p:nvPr>
          </p:nvGraphicFramePr>
          <p:xfrm>
            <a:off x="3951347" y="4342495"/>
            <a:ext cx="1043718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3480712" imgH="4242975" progId="Prism9.Document">
                    <p:embed/>
                  </p:oleObj>
                </mc:Choice>
                <mc:Fallback>
                  <p:oleObj name="Prism 9" r:id="rId5" imgW="3480712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951347" y="4342495"/>
                          <a:ext cx="1043718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8" name="Object 3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7736759"/>
                </p:ext>
              </p:extLst>
            </p:nvPr>
          </p:nvGraphicFramePr>
          <p:xfrm>
            <a:off x="4694368" y="4341297"/>
            <a:ext cx="1040770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3480712" imgH="4242975" progId="Prism9.Document">
                    <p:embed/>
                  </p:oleObj>
                </mc:Choice>
                <mc:Fallback>
                  <p:oleObj name="Prism 9" r:id="rId7" imgW="3480712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694368" y="4341297"/>
                          <a:ext cx="1040770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1" name="Object 4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31507104"/>
                </p:ext>
              </p:extLst>
            </p:nvPr>
          </p:nvGraphicFramePr>
          <p:xfrm>
            <a:off x="5400160" y="4342405"/>
            <a:ext cx="104277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3480712" imgH="4242975" progId="Prism9.Document">
                    <p:embed/>
                  </p:oleObj>
                </mc:Choice>
                <mc:Fallback>
                  <p:oleObj name="Prism 9" r:id="rId9" imgW="3480712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400160" y="4342405"/>
                          <a:ext cx="104277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64" name="Group 63"/>
          <p:cNvGrpSpPr/>
          <p:nvPr/>
        </p:nvGrpSpPr>
        <p:grpSpPr>
          <a:xfrm>
            <a:off x="93735" y="4284663"/>
            <a:ext cx="3120953" cy="1276700"/>
            <a:chOff x="166077" y="1885104"/>
            <a:chExt cx="3120953" cy="1276700"/>
          </a:xfrm>
        </p:grpSpPr>
        <p:graphicFrame>
          <p:nvGraphicFramePr>
            <p:cNvPr id="50" name="Object 4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14071243"/>
                </p:ext>
              </p:extLst>
            </p:nvPr>
          </p:nvGraphicFramePr>
          <p:xfrm>
            <a:off x="166077" y="1891804"/>
            <a:ext cx="954087" cy="127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3157310" imgH="4203358" progId="Prism9.Document">
                    <p:embed/>
                  </p:oleObj>
                </mc:Choice>
                <mc:Fallback>
                  <p:oleObj name="Prism 9" r:id="rId11" imgW="3157310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166077" y="1891804"/>
                          <a:ext cx="954087" cy="127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1" name="Object 5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93294420"/>
                </p:ext>
              </p:extLst>
            </p:nvPr>
          </p:nvGraphicFramePr>
          <p:xfrm>
            <a:off x="1102190" y="1890112"/>
            <a:ext cx="732946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2424073" imgH="4203358" progId="Prism9.Document">
                    <p:embed/>
                  </p:oleObj>
                </mc:Choice>
                <mc:Fallback>
                  <p:oleObj name="Prism 9" r:id="rId13" imgW="2424073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102190" y="1890112"/>
                          <a:ext cx="732946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2" name="Object 5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33030606"/>
                </p:ext>
              </p:extLst>
            </p:nvPr>
          </p:nvGraphicFramePr>
          <p:xfrm>
            <a:off x="1807480" y="1885104"/>
            <a:ext cx="733425" cy="12747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2424073" imgH="4212722" progId="Prism9.Document">
                    <p:embed/>
                  </p:oleObj>
                </mc:Choice>
                <mc:Fallback>
                  <p:oleObj name="Prism 9" r:id="rId15" imgW="2424073" imgH="421272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807480" y="1885104"/>
                          <a:ext cx="733425" cy="12747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3" name="Object 5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65612115"/>
                </p:ext>
              </p:extLst>
            </p:nvPr>
          </p:nvGraphicFramePr>
          <p:xfrm>
            <a:off x="2421842" y="1885104"/>
            <a:ext cx="865188" cy="1271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7" imgW="2860198" imgH="4203358" progId="Prism9.Document">
                    <p:embed/>
                  </p:oleObj>
                </mc:Choice>
                <mc:Fallback>
                  <p:oleObj name="Prism 9" r:id="rId17" imgW="2860198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2421842" y="1885104"/>
                          <a:ext cx="865188" cy="1271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49" name="Group 48"/>
          <p:cNvGrpSpPr/>
          <p:nvPr/>
        </p:nvGrpSpPr>
        <p:grpSpPr>
          <a:xfrm>
            <a:off x="150105" y="-254324"/>
            <a:ext cx="6135169" cy="2318494"/>
            <a:chOff x="84935" y="-299999"/>
            <a:chExt cx="5573230" cy="2429087"/>
          </a:xfrm>
        </p:grpSpPr>
        <p:grpSp>
          <p:nvGrpSpPr>
            <p:cNvPr id="45" name="Group 44"/>
            <p:cNvGrpSpPr/>
            <p:nvPr/>
          </p:nvGrpSpPr>
          <p:grpSpPr>
            <a:xfrm>
              <a:off x="292984" y="-299999"/>
              <a:ext cx="4964441" cy="2429087"/>
              <a:chOff x="292984" y="-299999"/>
              <a:chExt cx="4964441" cy="2429087"/>
            </a:xfrm>
          </p:grpSpPr>
          <p:grpSp>
            <p:nvGrpSpPr>
              <p:cNvPr id="44" name="Group 43"/>
              <p:cNvGrpSpPr/>
              <p:nvPr/>
            </p:nvGrpSpPr>
            <p:grpSpPr>
              <a:xfrm>
                <a:off x="292984" y="-299999"/>
                <a:ext cx="4964441" cy="2429087"/>
                <a:chOff x="292984" y="-299999"/>
                <a:chExt cx="4964441" cy="2429087"/>
              </a:xfrm>
            </p:grpSpPr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C0FF1097-3CFE-35FD-DF31-FE4C7199D70D}"/>
                    </a:ext>
                  </a:extLst>
                </p:cNvPr>
                <p:cNvSpPr txBox="1"/>
                <p:nvPr/>
              </p:nvSpPr>
              <p:spPr>
                <a:xfrm rot="16200000">
                  <a:off x="-786593" y="779578"/>
                  <a:ext cx="2429087" cy="269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-17A</a:t>
                  </a:r>
                </a:p>
              </p:txBody>
            </p:sp>
            <p:grpSp>
              <p:nvGrpSpPr>
                <p:cNvPr id="2" name="Group 1"/>
                <p:cNvGrpSpPr/>
                <p:nvPr/>
              </p:nvGrpSpPr>
              <p:grpSpPr>
                <a:xfrm>
                  <a:off x="491445" y="118327"/>
                  <a:ext cx="4653533" cy="1545793"/>
                  <a:chOff x="212725" y="30480"/>
                  <a:chExt cx="4653533" cy="1545793"/>
                </a:xfrm>
              </p:grpSpPr>
              <p:pic>
                <p:nvPicPr>
                  <p:cNvPr id="24" name="Picture 23">
                    <a:extLst>
                      <a:ext uri="{FF2B5EF4-FFF2-40B4-BE49-F238E27FC236}">
                        <a16:creationId xmlns:a16="http://schemas.microsoft.com/office/drawing/2014/main" id="{648C16AF-427F-EA9C-22D8-78C733BFC5C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9"/>
                  <a:srcRect l="5654" b="5063"/>
                  <a:stretch/>
                </p:blipFill>
                <p:spPr>
                  <a:xfrm>
                    <a:off x="212725" y="35811"/>
                    <a:ext cx="1565848" cy="1536268"/>
                  </a:xfrm>
                  <a:prstGeom prst="rect">
                    <a:avLst/>
                  </a:prstGeom>
                </p:spPr>
              </p:pic>
              <p:pic>
                <p:nvPicPr>
                  <p:cNvPr id="23" name="Picture 22">
                    <a:extLst>
                      <a:ext uri="{FF2B5EF4-FFF2-40B4-BE49-F238E27FC236}">
                        <a16:creationId xmlns:a16="http://schemas.microsoft.com/office/drawing/2014/main" id="{7EFBD0B7-DDA1-C065-711D-3097E407AB6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0"/>
                  <a:srcRect l="5659" b="5849"/>
                  <a:stretch/>
                </p:blipFill>
                <p:spPr>
                  <a:xfrm>
                    <a:off x="3300484" y="30713"/>
                    <a:ext cx="1565774" cy="1523546"/>
                  </a:xfrm>
                  <a:prstGeom prst="rect">
                    <a:avLst/>
                  </a:prstGeom>
                </p:spPr>
              </p:pic>
              <p:pic>
                <p:nvPicPr>
                  <p:cNvPr id="25" name="Picture 24">
                    <a:extLst>
                      <a:ext uri="{FF2B5EF4-FFF2-40B4-BE49-F238E27FC236}">
                        <a16:creationId xmlns:a16="http://schemas.microsoft.com/office/drawing/2014/main" id="{3D74FBF1-9AF4-2734-E7A2-1693A32B9FF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1"/>
                  <a:srcRect l="7426" b="4474"/>
                  <a:stretch/>
                </p:blipFill>
                <p:spPr>
                  <a:xfrm>
                    <a:off x="1775335" y="30480"/>
                    <a:ext cx="1536443" cy="1545793"/>
                  </a:xfrm>
                  <a:prstGeom prst="rect">
                    <a:avLst/>
                  </a:prstGeom>
                </p:spPr>
              </p:pic>
            </p:grpSp>
            <p:cxnSp>
              <p:nvCxnSpPr>
                <p:cNvPr id="39" name="Straight Arrow Connector 38"/>
                <p:cNvCxnSpPr/>
                <p:nvPr/>
              </p:nvCxnSpPr>
              <p:spPr>
                <a:xfrm flipV="1">
                  <a:off x="502545" y="1659926"/>
                  <a:ext cx="4754880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C0FF1097-3CFE-35FD-DF31-FE4C7199D70D}"/>
                    </a:ext>
                  </a:extLst>
                </p:cNvPr>
                <p:cNvSpPr txBox="1"/>
                <p:nvPr/>
              </p:nvSpPr>
              <p:spPr>
                <a:xfrm>
                  <a:off x="1738129" y="1642105"/>
                  <a:ext cx="2429087" cy="269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OR</a:t>
                  </a:r>
                  <a:r>
                    <a:rPr lang="en-US" sz="700" dirty="0">
                      <a:latin typeface="Symbol" panose="05050102010706020507" pitchFamily="18" charset="2"/>
                      <a:cs typeface="Arial" panose="020B0604020202020204" pitchFamily="34" charset="0"/>
                    </a:rPr>
                    <a:t>g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</a:p>
              </p:txBody>
            </p:sp>
          </p:grpSp>
          <p:cxnSp>
            <p:nvCxnSpPr>
              <p:cNvPr id="40" name="Straight Arrow Connector 39"/>
              <p:cNvCxnSpPr/>
              <p:nvPr/>
            </p:nvCxnSpPr>
            <p:spPr>
              <a:xfrm flipV="1">
                <a:off x="498338" y="151166"/>
                <a:ext cx="0" cy="15087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0FF1097-3CFE-35FD-DF31-FE4C7199D70D}"/>
                </a:ext>
              </a:extLst>
            </p:cNvPr>
            <p:cNvSpPr txBox="1"/>
            <p:nvPr/>
          </p:nvSpPr>
          <p:spPr>
            <a:xfrm>
              <a:off x="84935" y="-33014"/>
              <a:ext cx="2429087" cy="269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0FF1097-3CFE-35FD-DF31-FE4C7199D70D}"/>
                </a:ext>
              </a:extLst>
            </p:cNvPr>
            <p:cNvSpPr txBox="1"/>
            <p:nvPr/>
          </p:nvSpPr>
          <p:spPr>
            <a:xfrm>
              <a:off x="1698607" y="-35158"/>
              <a:ext cx="2429087" cy="269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X31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mod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C0FF1097-3CFE-35FD-DF31-FE4C7199D70D}"/>
                </a:ext>
              </a:extLst>
            </p:cNvPr>
            <p:cNvSpPr txBox="1"/>
            <p:nvPr/>
          </p:nvSpPr>
          <p:spPr>
            <a:xfrm>
              <a:off x="3229078" y="-39147"/>
              <a:ext cx="2429087" cy="269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X31</a:t>
              </a:r>
              <a:r>
                <a:rPr lang="en-US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</a:p>
          </p:txBody>
        </p:sp>
      </p:grpSp>
      <p:sp>
        <p:nvSpPr>
          <p:cNvPr id="110" name="TextBox 109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30784" y="-5816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20260" y="1845236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18858" y="3012381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90" name="Group 89">
            <a:extLst>
              <a:ext uri="{FF2B5EF4-FFF2-40B4-BE49-F238E27FC236}">
                <a16:creationId xmlns:a16="http://schemas.microsoft.com/office/drawing/2014/main" id="{3DA8F97E-9C28-BF15-A936-58342D1D2223}"/>
              </a:ext>
            </a:extLst>
          </p:cNvPr>
          <p:cNvGrpSpPr/>
          <p:nvPr/>
        </p:nvGrpSpPr>
        <p:grpSpPr>
          <a:xfrm>
            <a:off x="596722" y="5509345"/>
            <a:ext cx="2004809" cy="202923"/>
            <a:chOff x="1506483" y="7822115"/>
            <a:chExt cx="2705087" cy="273806"/>
          </a:xfrm>
        </p:grpSpPr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2ACD7942-8D0F-106D-0064-AC746F44ED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06483" y="7822115"/>
              <a:ext cx="2705087" cy="273806"/>
              <a:chOff x="2376664" y="4624110"/>
              <a:chExt cx="2654130" cy="268646"/>
            </a:xfrm>
          </p:grpSpPr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AF1BBFB5-F136-74A5-EC62-385A26239619}"/>
                  </a:ext>
                </a:extLst>
              </p:cNvPr>
              <p:cNvSpPr txBox="1"/>
              <p:nvPr/>
            </p:nvSpPr>
            <p:spPr>
              <a:xfrm>
                <a:off x="2376664" y="4624113"/>
                <a:ext cx="985119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 dpi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gend: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3B9872B2-9D1A-EB02-54AB-9FF97973659E}"/>
                  </a:ext>
                </a:extLst>
              </p:cNvPr>
              <p:cNvSpPr txBox="1"/>
              <p:nvPr/>
            </p:nvSpPr>
            <p:spPr>
              <a:xfrm>
                <a:off x="3333982" y="4624111"/>
                <a:ext cx="460938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2B696D2C-658E-0F65-BAA3-0FAA9CA6BEDC}"/>
                  </a:ext>
                </a:extLst>
              </p:cNvPr>
              <p:cNvSpPr txBox="1"/>
              <p:nvPr/>
            </p:nvSpPr>
            <p:spPr>
              <a:xfrm>
                <a:off x="3880066" y="4624110"/>
                <a:ext cx="609490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mod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9AB4959C-3B6C-CA70-04B7-A0075AB99D90}"/>
                  </a:ext>
                </a:extLst>
              </p:cNvPr>
              <p:cNvSpPr txBox="1"/>
              <p:nvPr/>
            </p:nvSpPr>
            <p:spPr>
              <a:xfrm>
                <a:off x="4514678" y="4624111"/>
                <a:ext cx="516116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</p:txBody>
          </p:sp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id="{7A2596D0-46BE-4279-A5B3-59C91930BE6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456454" y="4628884"/>
                <a:ext cx="2542170" cy="2638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2448212" y="7912323"/>
              <a:ext cx="93196" cy="93196"/>
            </a:xfrm>
            <a:prstGeom prst="rect">
              <a:avLst/>
            </a:prstGeom>
            <a:solidFill>
              <a:srgbClr val="AFAF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3005169" y="7912323"/>
              <a:ext cx="93196" cy="93196"/>
            </a:xfrm>
            <a:prstGeom prst="rect">
              <a:avLst/>
            </a:prstGeom>
            <a:solidFill>
              <a:srgbClr val="21A7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3626556" y="7912323"/>
              <a:ext cx="93196" cy="93196"/>
            </a:xfrm>
            <a:prstGeom prst="rect">
              <a:avLst/>
            </a:prstGeom>
            <a:solidFill>
              <a:srgbClr val="166D74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3DA8F97E-9C28-BF15-A936-58342D1D2223}"/>
              </a:ext>
            </a:extLst>
          </p:cNvPr>
          <p:cNvGrpSpPr/>
          <p:nvPr/>
        </p:nvGrpSpPr>
        <p:grpSpPr>
          <a:xfrm>
            <a:off x="3823605" y="5506478"/>
            <a:ext cx="2004809" cy="202923"/>
            <a:chOff x="1506483" y="7822115"/>
            <a:chExt cx="2705087" cy="273806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2ACD7942-8D0F-106D-0064-AC746F44ED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06483" y="7822115"/>
              <a:ext cx="2705087" cy="273806"/>
              <a:chOff x="2376664" y="4624110"/>
              <a:chExt cx="2654130" cy="268646"/>
            </a:xfrm>
          </p:grpSpPr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AF1BBFB5-F136-74A5-EC62-385A26239619}"/>
                  </a:ext>
                </a:extLst>
              </p:cNvPr>
              <p:cNvSpPr txBox="1"/>
              <p:nvPr/>
            </p:nvSpPr>
            <p:spPr>
              <a:xfrm>
                <a:off x="2376664" y="4624113"/>
                <a:ext cx="985119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 dpi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gend:</a:t>
                </a: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3B9872B2-9D1A-EB02-54AB-9FF97973659E}"/>
                  </a:ext>
                </a:extLst>
              </p:cNvPr>
              <p:cNvSpPr txBox="1"/>
              <p:nvPr/>
            </p:nvSpPr>
            <p:spPr>
              <a:xfrm>
                <a:off x="3333982" y="4624111"/>
                <a:ext cx="460938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2B696D2C-658E-0F65-BAA3-0FAA9CA6BEDC}"/>
                  </a:ext>
                </a:extLst>
              </p:cNvPr>
              <p:cNvSpPr txBox="1"/>
              <p:nvPr/>
            </p:nvSpPr>
            <p:spPr>
              <a:xfrm>
                <a:off x="3880066" y="4624110"/>
                <a:ext cx="609490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mod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9AB4959C-3B6C-CA70-04B7-A0075AB99D90}"/>
                  </a:ext>
                </a:extLst>
              </p:cNvPr>
              <p:cNvSpPr txBox="1"/>
              <p:nvPr/>
            </p:nvSpPr>
            <p:spPr>
              <a:xfrm>
                <a:off x="4514678" y="4624111"/>
                <a:ext cx="516116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</p:txBody>
          </p:sp>
          <p:sp>
            <p:nvSpPr>
              <p:cNvPr id="124" name="Rectangle 123">
                <a:extLst>
                  <a:ext uri="{FF2B5EF4-FFF2-40B4-BE49-F238E27FC236}">
                    <a16:creationId xmlns:a16="http://schemas.microsoft.com/office/drawing/2014/main" id="{7A2596D0-46BE-4279-A5B3-59C91930BE6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456454" y="4628884"/>
                <a:ext cx="2542170" cy="2638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2448212" y="7912323"/>
              <a:ext cx="93196" cy="93196"/>
            </a:xfrm>
            <a:prstGeom prst="rect">
              <a:avLst/>
            </a:prstGeom>
            <a:solidFill>
              <a:srgbClr val="AFAF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3005169" y="7912323"/>
              <a:ext cx="93196" cy="93196"/>
            </a:xfrm>
            <a:prstGeom prst="rect">
              <a:avLst/>
            </a:prstGeom>
            <a:solidFill>
              <a:srgbClr val="BA477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3626556" y="7912323"/>
              <a:ext cx="93196" cy="93196"/>
            </a:xfrm>
            <a:prstGeom prst="rect">
              <a:avLst/>
            </a:prstGeom>
            <a:solidFill>
              <a:srgbClr val="88335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EE02B525-FFA4-0B84-7AB9-B34A43894EC3}"/>
              </a:ext>
            </a:extLst>
          </p:cNvPr>
          <p:cNvSpPr txBox="1"/>
          <p:nvPr/>
        </p:nvSpPr>
        <p:spPr>
          <a:xfrm flipH="1">
            <a:off x="3120438" y="1851072"/>
            <a:ext cx="741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8E6F3F-D06C-9951-7283-8FA123A8B0A6}"/>
              </a:ext>
            </a:extLst>
          </p:cNvPr>
          <p:cNvSpPr txBox="1"/>
          <p:nvPr/>
        </p:nvSpPr>
        <p:spPr>
          <a:xfrm>
            <a:off x="3227625" y="3023931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54C02C-95D3-F620-40FA-DD189B8DF70D}"/>
              </a:ext>
            </a:extLst>
          </p:cNvPr>
          <p:cNvSpPr txBox="1"/>
          <p:nvPr/>
        </p:nvSpPr>
        <p:spPr>
          <a:xfrm>
            <a:off x="17239" y="4177555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8B293C5-92FA-4D0B-4A3D-23C2ED88179D}"/>
              </a:ext>
            </a:extLst>
          </p:cNvPr>
          <p:cNvSpPr txBox="1"/>
          <p:nvPr/>
        </p:nvSpPr>
        <p:spPr>
          <a:xfrm>
            <a:off x="3229877" y="4178058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pSp>
        <p:nvGrpSpPr>
          <p:cNvPr id="67" name="Group 66"/>
          <p:cNvGrpSpPr/>
          <p:nvPr/>
        </p:nvGrpSpPr>
        <p:grpSpPr>
          <a:xfrm>
            <a:off x="3251200" y="1882375"/>
            <a:ext cx="3335638" cy="1275792"/>
            <a:chOff x="3026196" y="3087989"/>
            <a:chExt cx="3335638" cy="1275792"/>
          </a:xfrm>
        </p:grpSpPr>
        <p:graphicFrame>
          <p:nvGraphicFramePr>
            <p:cNvPr id="13" name="Object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42577376"/>
                </p:ext>
              </p:extLst>
            </p:nvPr>
          </p:nvGraphicFramePr>
          <p:xfrm>
            <a:off x="3026196" y="3089977"/>
            <a:ext cx="1181100" cy="127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2" imgW="3944206" imgH="4242975" progId="Prism9.Document">
                    <p:embed/>
                  </p:oleObj>
                </mc:Choice>
                <mc:Fallback>
                  <p:oleObj name="Prism 9" r:id="rId22" imgW="3944206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3026196" y="3089977"/>
                          <a:ext cx="1181100" cy="127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25731218"/>
                </p:ext>
              </p:extLst>
            </p:nvPr>
          </p:nvGraphicFramePr>
          <p:xfrm>
            <a:off x="3869618" y="3092765"/>
            <a:ext cx="106103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4" imgW="3480712" imgH="4169863" progId="Prism9.Document">
                    <p:embed/>
                  </p:oleObj>
                </mc:Choice>
                <mc:Fallback>
                  <p:oleObj name="Prism 9" r:id="rId24" imgW="3480712" imgH="4169863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3869618" y="3092765"/>
                          <a:ext cx="106103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Object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05388598"/>
                </p:ext>
              </p:extLst>
            </p:nvPr>
          </p:nvGraphicFramePr>
          <p:xfrm>
            <a:off x="4610532" y="3092150"/>
            <a:ext cx="104277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6" imgW="3480712" imgH="4242975" progId="Prism9.Document">
                    <p:embed/>
                  </p:oleObj>
                </mc:Choice>
                <mc:Fallback>
                  <p:oleObj name="Prism 9" r:id="rId26" imgW="3480712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4610532" y="3092150"/>
                          <a:ext cx="104277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Object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30204106"/>
                </p:ext>
              </p:extLst>
            </p:nvPr>
          </p:nvGraphicFramePr>
          <p:xfrm>
            <a:off x="5319059" y="3087989"/>
            <a:ext cx="104277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8" imgW="3480712" imgH="4242975" progId="Prism9.Document">
                    <p:embed/>
                  </p:oleObj>
                </mc:Choice>
                <mc:Fallback>
                  <p:oleObj name="Prism 9" r:id="rId28" imgW="3480712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9"/>
                        <a:stretch>
                          <a:fillRect/>
                        </a:stretch>
                      </p:blipFill>
                      <p:spPr>
                        <a:xfrm>
                          <a:off x="5319059" y="3087989"/>
                          <a:ext cx="104277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65" name="Group 64"/>
          <p:cNvGrpSpPr/>
          <p:nvPr/>
        </p:nvGrpSpPr>
        <p:grpSpPr>
          <a:xfrm>
            <a:off x="3382817" y="4282572"/>
            <a:ext cx="3216421" cy="1278861"/>
            <a:chOff x="3225231" y="1877863"/>
            <a:chExt cx="3216421" cy="1278861"/>
          </a:xfrm>
        </p:grpSpPr>
        <p:graphicFrame>
          <p:nvGraphicFramePr>
            <p:cNvPr id="21" name="Object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87296794"/>
                </p:ext>
              </p:extLst>
            </p:nvPr>
          </p:nvGraphicFramePr>
          <p:xfrm>
            <a:off x="3225231" y="1877863"/>
            <a:ext cx="104277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0" imgW="3480712" imgH="4242975" progId="Prism9.Document">
                    <p:embed/>
                  </p:oleObj>
                </mc:Choice>
                <mc:Fallback>
                  <p:oleObj name="Prism 9" r:id="rId30" imgW="3480712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1"/>
                        <a:stretch>
                          <a:fillRect/>
                        </a:stretch>
                      </p:blipFill>
                      <p:spPr>
                        <a:xfrm>
                          <a:off x="3225231" y="1877863"/>
                          <a:ext cx="104277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Object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4308376"/>
                </p:ext>
              </p:extLst>
            </p:nvPr>
          </p:nvGraphicFramePr>
          <p:xfrm>
            <a:off x="3939521" y="1885708"/>
            <a:ext cx="104277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2" imgW="3480712" imgH="4242975" progId="Prism9.Document">
                    <p:embed/>
                  </p:oleObj>
                </mc:Choice>
                <mc:Fallback>
                  <p:oleObj name="Prism 9" r:id="rId32" imgW="3480712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3"/>
                        <a:stretch>
                          <a:fillRect/>
                        </a:stretch>
                      </p:blipFill>
                      <p:spPr>
                        <a:xfrm>
                          <a:off x="3939521" y="1885708"/>
                          <a:ext cx="104277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Object 2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52608154"/>
                </p:ext>
              </p:extLst>
            </p:nvPr>
          </p:nvGraphicFramePr>
          <p:xfrm>
            <a:off x="4680956" y="1884911"/>
            <a:ext cx="104277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4" imgW="3480712" imgH="4242975" progId="Prism9.Document">
                    <p:embed/>
                  </p:oleObj>
                </mc:Choice>
                <mc:Fallback>
                  <p:oleObj name="Prism 9" r:id="rId34" imgW="3480712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5"/>
                        <a:stretch>
                          <a:fillRect/>
                        </a:stretch>
                      </p:blipFill>
                      <p:spPr>
                        <a:xfrm>
                          <a:off x="4680956" y="1884911"/>
                          <a:ext cx="104277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5" name="Object 3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98032210"/>
                </p:ext>
              </p:extLst>
            </p:nvPr>
          </p:nvGraphicFramePr>
          <p:xfrm>
            <a:off x="5392314" y="1878366"/>
            <a:ext cx="1049338" cy="12715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6" imgW="3500519" imgH="4242975" progId="Prism9.Document">
                    <p:embed/>
                  </p:oleObj>
                </mc:Choice>
                <mc:Fallback>
                  <p:oleObj name="Prism 9" r:id="rId36" imgW="3500519" imgH="424297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7"/>
                        <a:stretch>
                          <a:fillRect/>
                        </a:stretch>
                      </p:blipFill>
                      <p:spPr>
                        <a:xfrm>
                          <a:off x="5392314" y="1878366"/>
                          <a:ext cx="1049338" cy="12715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66" name="Group 65"/>
          <p:cNvGrpSpPr/>
          <p:nvPr/>
        </p:nvGrpSpPr>
        <p:grpSpPr>
          <a:xfrm>
            <a:off x="142875" y="1890025"/>
            <a:ext cx="3065539" cy="1273462"/>
            <a:chOff x="229178" y="3083153"/>
            <a:chExt cx="3065539" cy="1273462"/>
          </a:xfrm>
        </p:grpSpPr>
        <p:graphicFrame>
          <p:nvGraphicFramePr>
            <p:cNvPr id="54" name="Object 5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98328090"/>
                </p:ext>
              </p:extLst>
            </p:nvPr>
          </p:nvGraphicFramePr>
          <p:xfrm>
            <a:off x="229178" y="3083841"/>
            <a:ext cx="906463" cy="127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8" imgW="2997410" imgH="4203358" progId="Prism9.Document">
                    <p:embed/>
                  </p:oleObj>
                </mc:Choice>
                <mc:Fallback>
                  <p:oleObj name="Prism 9" r:id="rId38" imgW="2997410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9"/>
                        <a:stretch>
                          <a:fillRect/>
                        </a:stretch>
                      </p:blipFill>
                      <p:spPr>
                        <a:xfrm>
                          <a:off x="229178" y="3083841"/>
                          <a:ext cx="906463" cy="127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7" name="Object 5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66580733"/>
                </p:ext>
              </p:extLst>
            </p:nvPr>
          </p:nvGraphicFramePr>
          <p:xfrm>
            <a:off x="2561771" y="3083153"/>
            <a:ext cx="732946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0" imgW="2424073" imgH="4203358" progId="Prism9.Document">
                    <p:embed/>
                  </p:oleObj>
                </mc:Choice>
                <mc:Fallback>
                  <p:oleObj name="Prism 9" r:id="rId40" imgW="2424073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1"/>
                        <a:stretch>
                          <a:fillRect/>
                        </a:stretch>
                      </p:blipFill>
                      <p:spPr>
                        <a:xfrm>
                          <a:off x="2561771" y="3083153"/>
                          <a:ext cx="732946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5" name="Object 5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89535005"/>
                </p:ext>
              </p:extLst>
            </p:nvPr>
          </p:nvGraphicFramePr>
          <p:xfrm>
            <a:off x="1124364" y="3085599"/>
            <a:ext cx="728271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2" imgW="2424073" imgH="4231090" progId="Prism9.Document">
                    <p:embed/>
                  </p:oleObj>
                </mc:Choice>
                <mc:Fallback>
                  <p:oleObj name="Prism 9" r:id="rId42" imgW="2424073" imgH="423109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3"/>
                        <a:stretch>
                          <a:fillRect/>
                        </a:stretch>
                      </p:blipFill>
                      <p:spPr>
                        <a:xfrm>
                          <a:off x="1124364" y="3085599"/>
                          <a:ext cx="728271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6" name="Object 5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75269986"/>
                </p:ext>
              </p:extLst>
            </p:nvPr>
          </p:nvGraphicFramePr>
          <p:xfrm>
            <a:off x="1781436" y="3083806"/>
            <a:ext cx="77518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4" imgW="2564166" imgH="4203358" progId="Prism9.Document">
                    <p:embed/>
                  </p:oleObj>
                </mc:Choice>
                <mc:Fallback>
                  <p:oleObj name="Prism 9" r:id="rId44" imgW="2564166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5"/>
                        <a:stretch>
                          <a:fillRect/>
                        </a:stretch>
                      </p:blipFill>
                      <p:spPr>
                        <a:xfrm>
                          <a:off x="1781436" y="3083806"/>
                          <a:ext cx="77518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80" name="Group 79"/>
          <p:cNvGrpSpPr/>
          <p:nvPr/>
        </p:nvGrpSpPr>
        <p:grpSpPr>
          <a:xfrm>
            <a:off x="143634" y="3049188"/>
            <a:ext cx="3069518" cy="1275000"/>
            <a:chOff x="229392" y="4354490"/>
            <a:chExt cx="3069518" cy="1275000"/>
          </a:xfrm>
        </p:grpSpPr>
        <p:graphicFrame>
          <p:nvGraphicFramePr>
            <p:cNvPr id="58" name="Object 5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11438417"/>
                </p:ext>
              </p:extLst>
            </p:nvPr>
          </p:nvGraphicFramePr>
          <p:xfrm>
            <a:off x="229392" y="4354983"/>
            <a:ext cx="907663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6" imgW="3001731" imgH="4203358" progId="Prism9.Document">
                    <p:embed/>
                  </p:oleObj>
                </mc:Choice>
                <mc:Fallback>
                  <p:oleObj name="Prism 9" r:id="rId46" imgW="3001731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7"/>
                        <a:stretch>
                          <a:fillRect/>
                        </a:stretch>
                      </p:blipFill>
                      <p:spPr>
                        <a:xfrm>
                          <a:off x="229392" y="4354983"/>
                          <a:ext cx="907663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9" name="Object 5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53573032"/>
                </p:ext>
              </p:extLst>
            </p:nvPr>
          </p:nvGraphicFramePr>
          <p:xfrm>
            <a:off x="1118999" y="4358474"/>
            <a:ext cx="732946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8" imgW="2424073" imgH="4203358" progId="Prism9.Document">
                    <p:embed/>
                  </p:oleObj>
                </mc:Choice>
                <mc:Fallback>
                  <p:oleObj name="Prism 9" r:id="rId48" imgW="2424073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9"/>
                        <a:stretch>
                          <a:fillRect/>
                        </a:stretch>
                      </p:blipFill>
                      <p:spPr>
                        <a:xfrm>
                          <a:off x="1118999" y="4358474"/>
                          <a:ext cx="732946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0" name="Object 5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05336412"/>
                </p:ext>
              </p:extLst>
            </p:nvPr>
          </p:nvGraphicFramePr>
          <p:xfrm>
            <a:off x="1777296" y="4355598"/>
            <a:ext cx="77518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0" imgW="2564166" imgH="4203358" progId="Prism9.Document">
                    <p:embed/>
                  </p:oleObj>
                </mc:Choice>
                <mc:Fallback>
                  <p:oleObj name="Prism 9" r:id="rId50" imgW="2564166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1"/>
                        <a:stretch>
                          <a:fillRect/>
                        </a:stretch>
                      </p:blipFill>
                      <p:spPr>
                        <a:xfrm>
                          <a:off x="1777296" y="4355598"/>
                          <a:ext cx="77518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1" name="Object 6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46931590"/>
                </p:ext>
              </p:extLst>
            </p:nvPr>
          </p:nvGraphicFramePr>
          <p:xfrm>
            <a:off x="2523725" y="4354490"/>
            <a:ext cx="775185" cy="12710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2" imgW="2564166" imgH="4203358" progId="Prism9.Document">
                    <p:embed/>
                  </p:oleObj>
                </mc:Choice>
                <mc:Fallback>
                  <p:oleObj name="Prism 9" r:id="rId52" imgW="2564166" imgH="420335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3"/>
                        <a:stretch>
                          <a:fillRect/>
                        </a:stretch>
                      </p:blipFill>
                      <p:spPr>
                        <a:xfrm>
                          <a:off x="2523725" y="4354490"/>
                          <a:ext cx="775185" cy="12710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85" name="TextBox 84"/>
          <p:cNvSpPr txBox="1"/>
          <p:nvPr/>
        </p:nvSpPr>
        <p:spPr>
          <a:xfrm>
            <a:off x="3982515" y="1704247"/>
            <a:ext cx="19627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7 dpi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878424" y="1705728"/>
            <a:ext cx="19627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2 dpi</a:t>
            </a:r>
          </a:p>
        </p:txBody>
      </p:sp>
    </p:spTree>
    <p:extLst>
      <p:ext uri="{BB962C8B-B14F-4D97-AF65-F5344CB8AC3E}">
        <p14:creationId xmlns:p14="http://schemas.microsoft.com/office/powerpoint/2010/main" val="37645232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9232D2C-DEBE-2BB9-97A5-DD3C2742FF6E}"/>
              </a:ext>
            </a:extLst>
          </p:cNvPr>
          <p:cNvSpPr txBox="1"/>
          <p:nvPr/>
        </p:nvSpPr>
        <p:spPr>
          <a:xfrm>
            <a:off x="0" y="0"/>
            <a:ext cx="6480174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4. Maternal colonic T</a:t>
            </a:r>
            <a:r>
              <a:rPr lang="en-US" sz="1200" b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7 and T</a:t>
            </a:r>
            <a:r>
              <a:rPr lang="en-US" sz="1200" b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 cells at 2 and 7 dpi. (A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presentative flow cytometry dot plots at 7 dpi of CD4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lonic LPLs quadrant gated on IL-17A and ROR</a:t>
            </a:r>
            <a:r>
              <a:rPr lang="en-US" sz="1200" dirty="0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 expression. Q6 represents double positive cells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-C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R</a:t>
            </a:r>
            <a:r>
              <a:rPr lang="en-US" sz="1200" dirty="0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T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7 cells) at 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 and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 dpi gated on IL-17A, IL-17F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N</a:t>
            </a:r>
            <a:r>
              <a:rPr lang="en-US" sz="1200" dirty="0" err="1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be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re is a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crease in IL-17F at both time points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-E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D4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bet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T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) at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 and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E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 dpi gated on IL-17A, IL-17F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N</a:t>
            </a:r>
            <a:r>
              <a:rPr lang="en-US" sz="1200" dirty="0" err="1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r</a:t>
            </a:r>
            <a:r>
              <a:rPr lang="en-US" sz="1200" dirty="0" err="1"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F-G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quadrant gating on CD4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CD4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R</a:t>
            </a:r>
            <a:r>
              <a:rPr lang="en-US" sz="1200" dirty="0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 cells at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F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 and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G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7 dpi.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V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nfluenza A virus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p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days post-inoculation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saline control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d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PL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lamina propria lymphocytes. Groups were compared with one-way ANOVA with Tukey post hoc for multiple comparisons. For data containing residuals with unequal variance, Brown-Forsythe and Welch’s ANOVA with Dunnett T3 post hoc multiple comparisons was used. For non-parametric data, Kruskal-Wallis ANOVA with Dunn’s correction for multiple comparisons was used. Data are means ± SEM; * = p &lt; 0.05, ** = p &lt; 0.01, *** = p &lt; 0.001; dots represent individual dams; n = 7-10 per treatment group. </a:t>
            </a:r>
            <a:endParaRPr lang="en-US" sz="1400" b="1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4876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0" y="18958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-10160" y="1379867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6" name="Group 25"/>
          <p:cNvGrpSpPr/>
          <p:nvPr/>
        </p:nvGrpSpPr>
        <p:grpSpPr>
          <a:xfrm>
            <a:off x="345705" y="48912"/>
            <a:ext cx="2091863" cy="1494976"/>
            <a:chOff x="8274" y="4314080"/>
            <a:chExt cx="2822542" cy="2017166"/>
          </a:xfrm>
        </p:grpSpPr>
        <p:graphicFrame>
          <p:nvGraphicFramePr>
            <p:cNvPr id="28" name="Object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00392252"/>
                </p:ext>
              </p:extLst>
            </p:nvPr>
          </p:nvGraphicFramePr>
          <p:xfrm>
            <a:off x="8274" y="4320159"/>
            <a:ext cx="1522378" cy="20110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3174236" imgH="4194354" progId="Prism9.Document">
                    <p:embed/>
                  </p:oleObj>
                </mc:Choice>
                <mc:Fallback>
                  <p:oleObj name="Prism 9" r:id="rId3" imgW="3174236" imgH="4194354" progId="Prism9.Document">
                    <p:embed/>
                    <p:pic>
                      <p:nvPicPr>
                        <p:cNvPr id="28" name="Object 27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274" y="4320159"/>
                          <a:ext cx="1522378" cy="20110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1" name="Object 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94368046"/>
                </p:ext>
              </p:extLst>
            </p:nvPr>
          </p:nvGraphicFramePr>
          <p:xfrm>
            <a:off x="1532398" y="4314080"/>
            <a:ext cx="1298418" cy="201197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2706060" imgH="4194354" progId="Prism9.Document">
                    <p:embed/>
                  </p:oleObj>
                </mc:Choice>
                <mc:Fallback>
                  <p:oleObj name="Prism 9" r:id="rId5" imgW="2706060" imgH="4194354" progId="Prism9.Document">
                    <p:embed/>
                    <p:pic>
                      <p:nvPicPr>
                        <p:cNvPr id="31" name="Object 30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532398" y="4314080"/>
                          <a:ext cx="1298418" cy="201197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2" name="Group 31"/>
          <p:cNvGrpSpPr/>
          <p:nvPr/>
        </p:nvGrpSpPr>
        <p:grpSpPr>
          <a:xfrm>
            <a:off x="352903" y="1366858"/>
            <a:ext cx="2071503" cy="1358849"/>
            <a:chOff x="5097483" y="4978776"/>
            <a:chExt cx="2795072" cy="1833489"/>
          </a:xfrm>
        </p:grpSpPr>
        <p:graphicFrame>
          <p:nvGraphicFramePr>
            <p:cNvPr id="43" name="Object 4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25167049"/>
                </p:ext>
              </p:extLst>
            </p:nvPr>
          </p:nvGraphicFramePr>
          <p:xfrm>
            <a:off x="5097483" y="4978776"/>
            <a:ext cx="1495424" cy="18288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3174236" imgH="3881740" progId="Prism9.Document">
                    <p:embed/>
                  </p:oleObj>
                </mc:Choice>
                <mc:Fallback>
                  <p:oleObj name="Prism 9" r:id="rId7" imgW="3174236" imgH="3881740" progId="Prism9.Document">
                    <p:embed/>
                    <p:pic>
                      <p:nvPicPr>
                        <p:cNvPr id="43" name="Object 42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5097483" y="4978776"/>
                          <a:ext cx="1495424" cy="18288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4" name="Object 4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80663862"/>
                </p:ext>
              </p:extLst>
            </p:nvPr>
          </p:nvGraphicFramePr>
          <p:xfrm>
            <a:off x="6586826" y="4983463"/>
            <a:ext cx="1305729" cy="182880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2706060" imgH="3790261" progId="Prism9.Document">
                    <p:embed/>
                  </p:oleObj>
                </mc:Choice>
                <mc:Fallback>
                  <p:oleObj name="Prism 9" r:id="rId9" imgW="2706060" imgH="3790261" progId="Prism9.Document">
                    <p:embed/>
                    <p:pic>
                      <p:nvPicPr>
                        <p:cNvPr id="44" name="Object 43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6586826" y="4983463"/>
                          <a:ext cx="1305729" cy="182880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DA8F97E-9C28-BF15-A936-58342D1D2223}"/>
              </a:ext>
            </a:extLst>
          </p:cNvPr>
          <p:cNvGrpSpPr/>
          <p:nvPr/>
        </p:nvGrpSpPr>
        <p:grpSpPr>
          <a:xfrm>
            <a:off x="504773" y="2613793"/>
            <a:ext cx="2004809" cy="202923"/>
            <a:chOff x="1506483" y="7822115"/>
            <a:chExt cx="2705087" cy="273806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2ACD7942-8D0F-106D-0064-AC746F44ED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06483" y="7822115"/>
              <a:ext cx="2705087" cy="273806"/>
              <a:chOff x="2376664" y="4624110"/>
              <a:chExt cx="2654130" cy="268646"/>
            </a:xfrm>
          </p:grpSpPr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F1BBFB5-F136-74A5-EC62-385A26239619}"/>
                  </a:ext>
                </a:extLst>
              </p:cNvPr>
              <p:cNvSpPr txBox="1"/>
              <p:nvPr/>
            </p:nvSpPr>
            <p:spPr>
              <a:xfrm>
                <a:off x="2376664" y="4624113"/>
                <a:ext cx="985119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 dpi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gend: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3B9872B2-9D1A-EB02-54AB-9FF97973659E}"/>
                  </a:ext>
                </a:extLst>
              </p:cNvPr>
              <p:cNvSpPr txBox="1"/>
              <p:nvPr/>
            </p:nvSpPr>
            <p:spPr>
              <a:xfrm>
                <a:off x="3333982" y="4624111"/>
                <a:ext cx="460938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2B696D2C-658E-0F65-BAA3-0FAA9CA6BEDC}"/>
                  </a:ext>
                </a:extLst>
              </p:cNvPr>
              <p:cNvSpPr txBox="1"/>
              <p:nvPr/>
            </p:nvSpPr>
            <p:spPr>
              <a:xfrm>
                <a:off x="3880066" y="4624110"/>
                <a:ext cx="609490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mod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9AB4959C-3B6C-CA70-04B7-A0075AB99D90}"/>
                  </a:ext>
                </a:extLst>
              </p:cNvPr>
              <p:cNvSpPr txBox="1"/>
              <p:nvPr/>
            </p:nvSpPr>
            <p:spPr>
              <a:xfrm>
                <a:off x="4514678" y="4624111"/>
                <a:ext cx="516116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</p:txBody>
          </p: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7A2596D0-46BE-4279-A5B3-59C91930BE6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456454" y="4628884"/>
                <a:ext cx="2542170" cy="2638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2448212" y="7912323"/>
              <a:ext cx="93196" cy="93196"/>
            </a:xfrm>
            <a:prstGeom prst="rect">
              <a:avLst/>
            </a:prstGeom>
            <a:solidFill>
              <a:srgbClr val="AFAF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3005169" y="7912323"/>
              <a:ext cx="93196" cy="93196"/>
            </a:xfrm>
            <a:prstGeom prst="rect">
              <a:avLst/>
            </a:prstGeom>
            <a:solidFill>
              <a:srgbClr val="BA477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3626556" y="7912323"/>
              <a:ext cx="93196" cy="93196"/>
            </a:xfrm>
            <a:prstGeom prst="rect">
              <a:avLst/>
            </a:prstGeom>
            <a:solidFill>
              <a:srgbClr val="88335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1D24921E-5F86-0D82-A1C2-36C51DB8952C}"/>
              </a:ext>
            </a:extLst>
          </p:cNvPr>
          <p:cNvSpPr txBox="1"/>
          <p:nvPr/>
        </p:nvSpPr>
        <p:spPr>
          <a:xfrm>
            <a:off x="2579621" y="1750229"/>
            <a:ext cx="3718343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5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mispheric analysis of E16.5 fetal brain cortical layers. (A-B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FI of SATB2 and TBR1 in the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ight and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eft hemispheres at E16.5, 7 dpi reveal a downregulation in SATB2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eurons in fetal brains from X31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ams.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-D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 of left and right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TB2 and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BR1 MFI revealed no hemispheric differences within treatment groups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multiple unpaired T-tests)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AV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nfluenza A virus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p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days post-inoculation,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n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saline control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d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X31</a:t>
            </a:r>
            <a:r>
              <a:rPr lang="en-US" sz="1200" i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IAV-X31 10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CID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embryonic day,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F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mean fluorescence intensity. Groups were compared with one-way ANOVA with Tukey post hoc for multiple comparisons unless otherwise specified. Data are means ± SEM; * = p &lt; 0.05; dots represent one representative fetus per litter; n = 9-10 per treatment group.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2317000" y="23163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1834124"/>
              </p:ext>
            </p:extLst>
          </p:nvPr>
        </p:nvGraphicFramePr>
        <p:xfrm>
          <a:off x="4394290" y="62808"/>
          <a:ext cx="1791394" cy="14996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5098081" imgH="4267465" progId="Prism9.Document">
                  <p:embed/>
                </p:oleObj>
              </mc:Choice>
              <mc:Fallback>
                <p:oleObj name="Prism 9" r:id="rId11" imgW="5098081" imgH="426746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394290" y="62808"/>
                        <a:ext cx="1791394" cy="14996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0767779"/>
              </p:ext>
            </p:extLst>
          </p:nvPr>
        </p:nvGraphicFramePr>
        <p:xfrm>
          <a:off x="2589213" y="62865"/>
          <a:ext cx="1863725" cy="1500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5300838" imgH="4267465" progId="Prism9.Document">
                  <p:embed/>
                </p:oleObj>
              </mc:Choice>
              <mc:Fallback>
                <p:oleObj name="Prism 9" r:id="rId13" imgW="5300838" imgH="426746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589213" y="62865"/>
                        <a:ext cx="1863725" cy="1500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4" name="Group 33">
            <a:extLst>
              <a:ext uri="{FF2B5EF4-FFF2-40B4-BE49-F238E27FC236}">
                <a16:creationId xmlns:a16="http://schemas.microsoft.com/office/drawing/2014/main" id="{3DA8F97E-9C28-BF15-A936-58342D1D2223}"/>
              </a:ext>
            </a:extLst>
          </p:cNvPr>
          <p:cNvGrpSpPr/>
          <p:nvPr/>
        </p:nvGrpSpPr>
        <p:grpSpPr>
          <a:xfrm>
            <a:off x="3373549" y="1505895"/>
            <a:ext cx="2004809" cy="202923"/>
            <a:chOff x="1506483" y="7822115"/>
            <a:chExt cx="2705087" cy="273806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2ACD7942-8D0F-106D-0064-AC746F44ED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06483" y="7822115"/>
              <a:ext cx="2705087" cy="273806"/>
              <a:chOff x="2376664" y="4624110"/>
              <a:chExt cx="2654130" cy="268646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AF1BBFB5-F136-74A5-EC62-385A26239619}"/>
                  </a:ext>
                </a:extLst>
              </p:cNvPr>
              <p:cNvSpPr txBox="1"/>
              <p:nvPr/>
            </p:nvSpPr>
            <p:spPr>
              <a:xfrm>
                <a:off x="2376664" y="4624113"/>
                <a:ext cx="985119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 dpi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gend: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3B9872B2-9D1A-EB02-54AB-9FF97973659E}"/>
                  </a:ext>
                </a:extLst>
              </p:cNvPr>
              <p:cNvSpPr txBox="1"/>
              <p:nvPr/>
            </p:nvSpPr>
            <p:spPr>
              <a:xfrm>
                <a:off x="3333982" y="4624111"/>
                <a:ext cx="460938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2B696D2C-658E-0F65-BAA3-0FAA9CA6BEDC}"/>
                  </a:ext>
                </a:extLst>
              </p:cNvPr>
              <p:cNvSpPr txBox="1"/>
              <p:nvPr/>
            </p:nvSpPr>
            <p:spPr>
              <a:xfrm>
                <a:off x="3880066" y="4624110"/>
                <a:ext cx="609490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mod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9AB4959C-3B6C-CA70-04B7-A0075AB99D90}"/>
                  </a:ext>
                </a:extLst>
              </p:cNvPr>
              <p:cNvSpPr txBox="1"/>
              <p:nvPr/>
            </p:nvSpPr>
            <p:spPr>
              <a:xfrm>
                <a:off x="4514678" y="4624111"/>
                <a:ext cx="516116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</p:txBody>
          </p: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7A2596D0-46BE-4279-A5B3-59C91930BE6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456454" y="4628884"/>
                <a:ext cx="2542170" cy="2638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2448212" y="7912323"/>
              <a:ext cx="93196" cy="93196"/>
            </a:xfrm>
            <a:prstGeom prst="rect">
              <a:avLst/>
            </a:prstGeom>
            <a:solidFill>
              <a:srgbClr val="AFAF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3005169" y="7912323"/>
              <a:ext cx="93196" cy="93196"/>
            </a:xfrm>
            <a:prstGeom prst="rect">
              <a:avLst/>
            </a:prstGeom>
            <a:solidFill>
              <a:srgbClr val="BA477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3626556" y="7912323"/>
              <a:ext cx="93196" cy="93196"/>
            </a:xfrm>
            <a:prstGeom prst="rect">
              <a:avLst/>
            </a:prstGeom>
            <a:solidFill>
              <a:srgbClr val="88335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4083565" y="18958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9507538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oup 60"/>
          <p:cNvGrpSpPr/>
          <p:nvPr/>
        </p:nvGrpSpPr>
        <p:grpSpPr>
          <a:xfrm>
            <a:off x="4227399" y="2974450"/>
            <a:ext cx="2114664" cy="1262587"/>
            <a:chOff x="3791532" y="6619677"/>
            <a:chExt cx="2853306" cy="1703605"/>
          </a:xfrm>
        </p:grpSpPr>
        <p:graphicFrame>
          <p:nvGraphicFramePr>
            <p:cNvPr id="62" name="Object 6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05557427"/>
                </p:ext>
              </p:extLst>
            </p:nvPr>
          </p:nvGraphicFramePr>
          <p:xfrm>
            <a:off x="5156143" y="6622527"/>
            <a:ext cx="1488695" cy="170075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3316130" imgH="3790261" progId="Prism9.Document">
                    <p:embed/>
                  </p:oleObj>
                </mc:Choice>
                <mc:Fallback>
                  <p:oleObj name="Prism 9" r:id="rId3" imgW="3316130" imgH="3790261" progId="Prism9.Document">
                    <p:embed/>
                    <p:pic>
                      <p:nvPicPr>
                        <p:cNvPr id="16" name="Object 15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156143" y="6622527"/>
                          <a:ext cx="1488695" cy="170075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3" name="Object 6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65421542"/>
                </p:ext>
              </p:extLst>
            </p:nvPr>
          </p:nvGraphicFramePr>
          <p:xfrm>
            <a:off x="3791532" y="6619677"/>
            <a:ext cx="1447996" cy="170075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3230417" imgH="3790261" progId="Prism9.Document">
                    <p:embed/>
                  </p:oleObj>
                </mc:Choice>
                <mc:Fallback>
                  <p:oleObj name="Prism 9" r:id="rId5" imgW="3230417" imgH="3790261" progId="Prism9.Document">
                    <p:embed/>
                    <p:pic>
                      <p:nvPicPr>
                        <p:cNvPr id="18" name="Object 17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791532" y="6619677"/>
                          <a:ext cx="1447996" cy="170075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2810514"/>
              </p:ext>
            </p:extLst>
          </p:nvPr>
        </p:nvGraphicFramePr>
        <p:xfrm>
          <a:off x="907019" y="4286949"/>
          <a:ext cx="786745" cy="11887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706060" imgH="4093871" progId="Prism9.Document">
                  <p:embed/>
                </p:oleObj>
              </mc:Choice>
              <mc:Fallback>
                <p:oleObj name="Prism 9" r:id="rId7" imgW="2706060" imgH="4093871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07019" y="4286949"/>
                        <a:ext cx="786745" cy="11887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0652753"/>
              </p:ext>
            </p:extLst>
          </p:nvPr>
        </p:nvGraphicFramePr>
        <p:xfrm>
          <a:off x="4091258" y="4287495"/>
          <a:ext cx="736759" cy="11887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2564166" imgH="4139611" progId="Prism9.Document">
                  <p:embed/>
                </p:oleObj>
              </mc:Choice>
              <mc:Fallback>
                <p:oleObj name="Prism 9" r:id="rId9" imgW="2564166" imgH="4139611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91258" y="4287495"/>
                        <a:ext cx="736759" cy="11887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9311452"/>
              </p:ext>
            </p:extLst>
          </p:nvPr>
        </p:nvGraphicFramePr>
        <p:xfrm>
          <a:off x="36331" y="4286694"/>
          <a:ext cx="960361" cy="11887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3326574" imgH="4111879" progId="Prism9.Document">
                  <p:embed/>
                </p:oleObj>
              </mc:Choice>
              <mc:Fallback>
                <p:oleObj name="Prism 9" r:id="rId11" imgW="3326574" imgH="4111879" progId="Prism9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6331" y="4286694"/>
                        <a:ext cx="960361" cy="11887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3778301"/>
              </p:ext>
            </p:extLst>
          </p:nvPr>
        </p:nvGraphicFramePr>
        <p:xfrm>
          <a:off x="3225435" y="4285507"/>
          <a:ext cx="942618" cy="11887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3293081" imgH="4157618" progId="Prism9.Document">
                  <p:embed/>
                </p:oleObj>
              </mc:Choice>
              <mc:Fallback>
                <p:oleObj name="Prism 9" r:id="rId13" imgW="3293081" imgH="4157618" progId="Prism9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225435" y="4285507"/>
                        <a:ext cx="942618" cy="11887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1506600"/>
              </p:ext>
            </p:extLst>
          </p:nvPr>
        </p:nvGraphicFramePr>
        <p:xfrm>
          <a:off x="4762729" y="4282249"/>
          <a:ext cx="923925" cy="118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3247344" imgH="4194354" progId="Prism9.Document">
                  <p:embed/>
                </p:oleObj>
              </mc:Choice>
              <mc:Fallback>
                <p:oleObj name="Prism 9" r:id="rId15" imgW="3247344" imgH="4194354" progId="Prism9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762729" y="4282249"/>
                        <a:ext cx="923925" cy="1187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9995251"/>
              </p:ext>
            </p:extLst>
          </p:nvPr>
        </p:nvGraphicFramePr>
        <p:xfrm>
          <a:off x="1598841" y="4285424"/>
          <a:ext cx="941388" cy="1189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7" imgW="3299203" imgH="4157618" progId="Prism9.Document">
                  <p:embed/>
                </p:oleObj>
              </mc:Choice>
              <mc:Fallback>
                <p:oleObj name="Prism 9" r:id="rId17" imgW="3299203" imgH="4157618" progId="Prism9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598841" y="4285424"/>
                        <a:ext cx="941388" cy="1189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9327520"/>
              </p:ext>
            </p:extLst>
          </p:nvPr>
        </p:nvGraphicFramePr>
        <p:xfrm>
          <a:off x="5639029" y="4291774"/>
          <a:ext cx="736600" cy="1184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9" imgW="2564166" imgH="4121243" progId="Prism9.Document">
                  <p:embed/>
                </p:oleObj>
              </mc:Choice>
              <mc:Fallback>
                <p:oleObj name="Prism 9" r:id="rId19" imgW="2564166" imgH="4121243" progId="Prism9.Document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639029" y="4291774"/>
                        <a:ext cx="736600" cy="1184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5831718"/>
              </p:ext>
            </p:extLst>
          </p:nvPr>
        </p:nvGraphicFramePr>
        <p:xfrm>
          <a:off x="2465616" y="4293362"/>
          <a:ext cx="731838" cy="118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1" imgW="2564166" imgH="4139611" progId="Prism9.Document">
                  <p:embed/>
                </p:oleObj>
              </mc:Choice>
              <mc:Fallback>
                <p:oleObj name="Prism 9" r:id="rId21" imgW="2564166" imgH="4139611" progId="Prism9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465616" y="4293362"/>
                        <a:ext cx="731838" cy="118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4367813" y="49523"/>
            <a:ext cx="9877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Iba1</a:t>
            </a:r>
            <a:r>
              <a:rPr lang="en-US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206</a:t>
            </a:r>
            <a:r>
              <a:rPr lang="en-US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(BAMs)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-36967" y="261777"/>
            <a:ext cx="1722438" cy="1189038"/>
            <a:chOff x="-96428" y="279400"/>
            <a:chExt cx="1722438" cy="1189038"/>
          </a:xfrm>
        </p:grpSpPr>
        <p:graphicFrame>
          <p:nvGraphicFramePr>
            <p:cNvPr id="24" name="Object 2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15012567"/>
                </p:ext>
              </p:extLst>
            </p:nvPr>
          </p:nvGraphicFramePr>
          <p:xfrm>
            <a:off x="-96428" y="282575"/>
            <a:ext cx="1035051" cy="1184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3" imgW="3619364" imgH="4139611" progId="Prism9.Document">
                    <p:embed/>
                  </p:oleObj>
                </mc:Choice>
                <mc:Fallback>
                  <p:oleObj name="Prism 9" r:id="rId23" imgW="3619364" imgH="4139611" progId="Prism9.Document">
                    <p:embed/>
                    <p:pic>
                      <p:nvPicPr>
                        <p:cNvPr id="24" name="Object 23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-96428" y="282575"/>
                          <a:ext cx="1035051" cy="1184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0593319"/>
                </p:ext>
              </p:extLst>
            </p:nvPr>
          </p:nvGraphicFramePr>
          <p:xfrm>
            <a:off x="886235" y="279400"/>
            <a:ext cx="739775" cy="11890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5" imgW="2564166" imgH="4130247" progId="Prism9.Document">
                    <p:embed/>
                  </p:oleObj>
                </mc:Choice>
                <mc:Fallback>
                  <p:oleObj name="Prism 9" r:id="rId25" imgW="2564166" imgH="4130247" progId="Prism9.Document">
                    <p:embed/>
                    <p:pic>
                      <p:nvPicPr>
                        <p:cNvPr id="28" name="Object 27"/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886235" y="279400"/>
                          <a:ext cx="739775" cy="11890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4" name="Group 13"/>
          <p:cNvGrpSpPr/>
          <p:nvPr/>
        </p:nvGrpSpPr>
        <p:grpSpPr>
          <a:xfrm>
            <a:off x="3217409" y="261345"/>
            <a:ext cx="1608246" cy="1188702"/>
            <a:chOff x="3157948" y="395187"/>
            <a:chExt cx="1608246" cy="1173163"/>
          </a:xfrm>
        </p:grpSpPr>
        <p:graphicFrame>
          <p:nvGraphicFramePr>
            <p:cNvPr id="25" name="Object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76206074"/>
                </p:ext>
              </p:extLst>
            </p:nvPr>
          </p:nvGraphicFramePr>
          <p:xfrm>
            <a:off x="3157948" y="396771"/>
            <a:ext cx="949325" cy="11703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7" imgW="3363307" imgH="4148614" progId="Prism9.Document">
                    <p:embed/>
                  </p:oleObj>
                </mc:Choice>
                <mc:Fallback>
                  <p:oleObj name="Prism 9" r:id="rId27" imgW="3363307" imgH="4148614" progId="Prism9.Document">
                    <p:embed/>
                    <p:pic>
                      <p:nvPicPr>
                        <p:cNvPr id="25" name="Object 24"/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3157948" y="396771"/>
                          <a:ext cx="949325" cy="11703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bject 2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21257071"/>
                </p:ext>
              </p:extLst>
            </p:nvPr>
          </p:nvGraphicFramePr>
          <p:xfrm>
            <a:off x="4042294" y="395187"/>
            <a:ext cx="723900" cy="1173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9" imgW="2564166" imgH="4157618" progId="Prism9.Document">
                    <p:embed/>
                  </p:oleObj>
                </mc:Choice>
                <mc:Fallback>
                  <p:oleObj name="Prism 9" r:id="rId29" imgW="2564166" imgH="4157618" progId="Prism9.Document">
                    <p:embed/>
                    <p:pic>
                      <p:nvPicPr>
                        <p:cNvPr id="29" name="Object 28"/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4042294" y="395187"/>
                          <a:ext cx="723900" cy="11731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8" name="TextBox 17"/>
          <p:cNvSpPr txBox="1"/>
          <p:nvPr/>
        </p:nvSpPr>
        <p:spPr>
          <a:xfrm>
            <a:off x="4662585" y="4101286"/>
            <a:ext cx="3738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602921" y="263365"/>
            <a:ext cx="1596615" cy="1190959"/>
            <a:chOff x="1492660" y="287318"/>
            <a:chExt cx="1596615" cy="1175372"/>
          </a:xfrm>
        </p:grpSpPr>
        <p:graphicFrame>
          <p:nvGraphicFramePr>
            <p:cNvPr id="35" name="Object 3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14653263"/>
                </p:ext>
              </p:extLst>
            </p:nvPr>
          </p:nvGraphicFramePr>
          <p:xfrm>
            <a:off x="2360613" y="291115"/>
            <a:ext cx="728662" cy="11715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1" imgW="2564166" imgH="4111879" progId="Prism9.Document">
                    <p:embed/>
                  </p:oleObj>
                </mc:Choice>
                <mc:Fallback>
                  <p:oleObj name="Prism 9" r:id="rId31" imgW="2564166" imgH="4111879" progId="Prism9.Document">
                    <p:embed/>
                    <p:pic>
                      <p:nvPicPr>
                        <p:cNvPr id="35" name="Object 34"/>
                        <p:cNvPicPr/>
                        <p:nvPr/>
                      </p:nvPicPr>
                      <p:blipFill>
                        <a:blip r:embed="rId32"/>
                        <a:stretch>
                          <a:fillRect/>
                        </a:stretch>
                      </p:blipFill>
                      <p:spPr>
                        <a:xfrm>
                          <a:off x="2360613" y="291115"/>
                          <a:ext cx="728662" cy="11715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2" name="Object 3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21160527"/>
                </p:ext>
              </p:extLst>
            </p:nvPr>
          </p:nvGraphicFramePr>
          <p:xfrm>
            <a:off x="1492660" y="287318"/>
            <a:ext cx="939800" cy="117191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3" imgW="3299203" imgH="4121243" progId="Prism9.Document">
                    <p:embed/>
                  </p:oleObj>
                </mc:Choice>
                <mc:Fallback>
                  <p:oleObj name="Prism 9" r:id="rId33" imgW="3299203" imgH="4121243" progId="Prism9.Document">
                    <p:embed/>
                    <p:pic>
                      <p:nvPicPr>
                        <p:cNvPr id="32" name="Object 31"/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1492660" y="287318"/>
                          <a:ext cx="939800" cy="117191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3" name="Group 12"/>
          <p:cNvGrpSpPr/>
          <p:nvPr/>
        </p:nvGrpSpPr>
        <p:grpSpPr>
          <a:xfrm>
            <a:off x="4731884" y="261345"/>
            <a:ext cx="1645332" cy="1188720"/>
            <a:chOff x="4672423" y="382570"/>
            <a:chExt cx="1645332" cy="1181100"/>
          </a:xfrm>
        </p:grpSpPr>
        <p:graphicFrame>
          <p:nvGraphicFramePr>
            <p:cNvPr id="59" name="Object 58"/>
            <p:cNvGraphicFramePr>
              <a:graphicFrameLocks noChangeAspect="1"/>
            </p:cNvGraphicFramePr>
            <p:nvPr/>
          </p:nvGraphicFramePr>
          <p:xfrm>
            <a:off x="5579568" y="382570"/>
            <a:ext cx="738187" cy="1181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5" imgW="2564166" imgH="4111879" progId="Prism9.Document">
                    <p:embed/>
                  </p:oleObj>
                </mc:Choice>
                <mc:Fallback>
                  <p:oleObj name="Prism 9" r:id="rId35" imgW="2564166" imgH="4111879" progId="Prism9.Document">
                    <p:embed/>
                    <p:pic>
                      <p:nvPicPr>
                        <p:cNvPr id="59" name="Object 58"/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5579568" y="382570"/>
                          <a:ext cx="738187" cy="1181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8" name="Object 57"/>
            <p:cNvGraphicFramePr>
              <a:graphicFrameLocks noChangeAspect="1"/>
            </p:cNvGraphicFramePr>
            <p:nvPr/>
          </p:nvGraphicFramePr>
          <p:xfrm>
            <a:off x="4672423" y="384165"/>
            <a:ext cx="966787" cy="11782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7" imgW="3353944" imgH="4121243" progId="Prism9.Document">
                    <p:embed/>
                  </p:oleObj>
                </mc:Choice>
                <mc:Fallback>
                  <p:oleObj name="Prism 9" r:id="rId37" imgW="3353944" imgH="4121243" progId="Prism9.Document">
                    <p:embed/>
                    <p:pic>
                      <p:nvPicPr>
                        <p:cNvPr id="58" name="Object 57"/>
                        <p:cNvPicPr/>
                        <p:nvPr/>
                      </p:nvPicPr>
                      <p:blipFill>
                        <a:blip r:embed="rId38"/>
                        <a:stretch>
                          <a:fillRect/>
                        </a:stretch>
                      </p:blipFill>
                      <p:spPr>
                        <a:xfrm>
                          <a:off x="4672423" y="384165"/>
                          <a:ext cx="966787" cy="11782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-61999" y="192188"/>
            <a:ext cx="525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-75366" y="4217622"/>
            <a:ext cx="525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3084905" y="197897"/>
            <a:ext cx="525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3112253" y="4220600"/>
            <a:ext cx="525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132043" y="48540"/>
            <a:ext cx="111440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Iba1</a:t>
            </a:r>
            <a:r>
              <a:rPr lang="en-US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206</a:t>
            </a:r>
            <a:r>
              <a:rPr lang="en-US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(Microglia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1412789" y="192188"/>
            <a:ext cx="525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4645695" y="191301"/>
            <a:ext cx="525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395528" y="4101054"/>
            <a:ext cx="62388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Iba1</a:t>
            </a:r>
            <a:r>
              <a:rPr lang="en-US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  <a:r>
              <a:rPr lang="en-US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1400733" y="4218566"/>
            <a:ext cx="525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4643087" y="4220555"/>
            <a:ext cx="525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grpSp>
        <p:nvGrpSpPr>
          <p:cNvPr id="66" name="Group 65">
            <a:extLst>
              <a:ext uri="{FF2B5EF4-FFF2-40B4-BE49-F238E27FC236}">
                <a16:creationId xmlns:a16="http://schemas.microsoft.com/office/drawing/2014/main" id="{3DA8F97E-9C28-BF15-A936-58342D1D2223}"/>
              </a:ext>
            </a:extLst>
          </p:cNvPr>
          <p:cNvGrpSpPr/>
          <p:nvPr/>
        </p:nvGrpSpPr>
        <p:grpSpPr>
          <a:xfrm>
            <a:off x="577201" y="5467602"/>
            <a:ext cx="2004809" cy="202923"/>
            <a:chOff x="1506483" y="7822115"/>
            <a:chExt cx="2705087" cy="273806"/>
          </a:xfrm>
        </p:grpSpPr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2ACD7942-8D0F-106D-0064-AC746F44ED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06483" y="7822115"/>
              <a:ext cx="2705087" cy="273806"/>
              <a:chOff x="2376664" y="4624110"/>
              <a:chExt cx="2654130" cy="268646"/>
            </a:xfrm>
          </p:grpSpPr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AF1BBFB5-F136-74A5-EC62-385A26239619}"/>
                  </a:ext>
                </a:extLst>
              </p:cNvPr>
              <p:cNvSpPr txBox="1"/>
              <p:nvPr/>
            </p:nvSpPr>
            <p:spPr>
              <a:xfrm>
                <a:off x="2376664" y="4624113"/>
                <a:ext cx="985119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 dpi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gend: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3B9872B2-9D1A-EB02-54AB-9FF97973659E}"/>
                  </a:ext>
                </a:extLst>
              </p:cNvPr>
              <p:cNvSpPr txBox="1"/>
              <p:nvPr/>
            </p:nvSpPr>
            <p:spPr>
              <a:xfrm>
                <a:off x="3333982" y="4624111"/>
                <a:ext cx="460938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2B696D2C-658E-0F65-BAA3-0FAA9CA6BEDC}"/>
                  </a:ext>
                </a:extLst>
              </p:cNvPr>
              <p:cNvSpPr txBox="1"/>
              <p:nvPr/>
            </p:nvSpPr>
            <p:spPr>
              <a:xfrm>
                <a:off x="3880066" y="4624110"/>
                <a:ext cx="609490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mod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9AB4959C-3B6C-CA70-04B7-A0075AB99D90}"/>
                  </a:ext>
                </a:extLst>
              </p:cNvPr>
              <p:cNvSpPr txBox="1"/>
              <p:nvPr/>
            </p:nvSpPr>
            <p:spPr>
              <a:xfrm>
                <a:off x="4514678" y="4624111"/>
                <a:ext cx="516116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</p:txBody>
          </p:sp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7A2596D0-46BE-4279-A5B3-59C91930BE6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456454" y="4628884"/>
                <a:ext cx="2542170" cy="2638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2448212" y="7912323"/>
              <a:ext cx="93196" cy="93196"/>
            </a:xfrm>
            <a:prstGeom prst="rect">
              <a:avLst/>
            </a:prstGeom>
            <a:solidFill>
              <a:srgbClr val="AFAF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3005169" y="7912323"/>
              <a:ext cx="93196" cy="93196"/>
            </a:xfrm>
            <a:prstGeom prst="rect">
              <a:avLst/>
            </a:prstGeom>
            <a:solidFill>
              <a:srgbClr val="21A7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3626556" y="7912323"/>
              <a:ext cx="93196" cy="93196"/>
            </a:xfrm>
            <a:prstGeom prst="rect">
              <a:avLst/>
            </a:prstGeom>
            <a:solidFill>
              <a:srgbClr val="166D74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3DA8F97E-9C28-BF15-A936-58342D1D2223}"/>
              </a:ext>
            </a:extLst>
          </p:cNvPr>
          <p:cNvGrpSpPr/>
          <p:nvPr/>
        </p:nvGrpSpPr>
        <p:grpSpPr>
          <a:xfrm>
            <a:off x="3824317" y="5467262"/>
            <a:ext cx="2004809" cy="202923"/>
            <a:chOff x="1506483" y="7822115"/>
            <a:chExt cx="2705087" cy="273806"/>
          </a:xfrm>
        </p:grpSpPr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2ACD7942-8D0F-106D-0064-AC746F44ED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06483" y="7822115"/>
              <a:ext cx="2705087" cy="273806"/>
              <a:chOff x="2376664" y="4624110"/>
              <a:chExt cx="2654130" cy="268646"/>
            </a:xfrm>
          </p:grpSpPr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AF1BBFB5-F136-74A5-EC62-385A26239619}"/>
                  </a:ext>
                </a:extLst>
              </p:cNvPr>
              <p:cNvSpPr txBox="1"/>
              <p:nvPr/>
            </p:nvSpPr>
            <p:spPr>
              <a:xfrm>
                <a:off x="2376664" y="4624113"/>
                <a:ext cx="985119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 dpi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gend: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3B9872B2-9D1A-EB02-54AB-9FF97973659E}"/>
                  </a:ext>
                </a:extLst>
              </p:cNvPr>
              <p:cNvSpPr txBox="1"/>
              <p:nvPr/>
            </p:nvSpPr>
            <p:spPr>
              <a:xfrm>
                <a:off x="3333982" y="4624111"/>
                <a:ext cx="460938" cy="2648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2B696D2C-658E-0F65-BAA3-0FAA9CA6BEDC}"/>
                  </a:ext>
                </a:extLst>
              </p:cNvPr>
              <p:cNvSpPr txBox="1"/>
              <p:nvPr/>
            </p:nvSpPr>
            <p:spPr>
              <a:xfrm>
                <a:off x="3880066" y="4624110"/>
                <a:ext cx="609490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mod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9AB4959C-3B6C-CA70-04B7-A0075AB99D90}"/>
                  </a:ext>
                </a:extLst>
              </p:cNvPr>
              <p:cNvSpPr txBox="1"/>
              <p:nvPr/>
            </p:nvSpPr>
            <p:spPr>
              <a:xfrm>
                <a:off x="4514678" y="4624111"/>
                <a:ext cx="516116" cy="2648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31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id="{7A2596D0-46BE-4279-A5B3-59C91930BE65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456454" y="4628884"/>
                <a:ext cx="2542170" cy="26387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D8BFDBB0-710E-C27A-78EE-DF914C34E7F7}"/>
                </a:ext>
              </a:extLst>
            </p:cNvPr>
            <p:cNvSpPr/>
            <p:nvPr/>
          </p:nvSpPr>
          <p:spPr>
            <a:xfrm>
              <a:off x="2448212" y="7912323"/>
              <a:ext cx="93196" cy="93196"/>
            </a:xfrm>
            <a:prstGeom prst="rect">
              <a:avLst/>
            </a:prstGeom>
            <a:solidFill>
              <a:srgbClr val="AFAFB2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0AD6776F-8AD9-CE0E-45CB-9A4DFFD09A92}"/>
                </a:ext>
              </a:extLst>
            </p:cNvPr>
            <p:cNvSpPr/>
            <p:nvPr/>
          </p:nvSpPr>
          <p:spPr>
            <a:xfrm>
              <a:off x="3005169" y="7912323"/>
              <a:ext cx="93196" cy="93196"/>
            </a:xfrm>
            <a:prstGeom prst="rect">
              <a:avLst/>
            </a:prstGeom>
            <a:solidFill>
              <a:srgbClr val="BA477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3259DBA0-AD77-8F85-227B-E980D6C79335}"/>
                </a:ext>
              </a:extLst>
            </p:cNvPr>
            <p:cNvSpPr/>
            <p:nvPr/>
          </p:nvSpPr>
          <p:spPr>
            <a:xfrm>
              <a:off x="3626556" y="7912323"/>
              <a:ext cx="93196" cy="93196"/>
            </a:xfrm>
            <a:prstGeom prst="rect">
              <a:avLst/>
            </a:prstGeom>
            <a:solidFill>
              <a:srgbClr val="883355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4186969" y="1585313"/>
            <a:ext cx="2138251" cy="1372823"/>
            <a:chOff x="4152047" y="3977673"/>
            <a:chExt cx="2885136" cy="1852348"/>
          </a:xfrm>
        </p:grpSpPr>
        <p:graphicFrame>
          <p:nvGraphicFramePr>
            <p:cNvPr id="56" name="Object 5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5569068"/>
                </p:ext>
              </p:extLst>
            </p:nvPr>
          </p:nvGraphicFramePr>
          <p:xfrm>
            <a:off x="4152047" y="3977673"/>
            <a:ext cx="1495090" cy="18506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9" imgW="3367629" imgH="4166982" progId="Prism9.Document">
                    <p:embed/>
                  </p:oleObj>
                </mc:Choice>
                <mc:Fallback>
                  <p:oleObj name="Prism 9" r:id="rId39" imgW="3367629" imgH="4166982" progId="Prism9.Document">
                    <p:embed/>
                    <p:pic>
                      <p:nvPicPr>
                        <p:cNvPr id="44" name="Object 43"/>
                        <p:cNvPicPr/>
                        <p:nvPr/>
                      </p:nvPicPr>
                      <p:blipFill>
                        <a:blip r:embed="rId40"/>
                        <a:stretch>
                          <a:fillRect/>
                        </a:stretch>
                      </p:blipFill>
                      <p:spPr>
                        <a:xfrm>
                          <a:off x="4152047" y="3977673"/>
                          <a:ext cx="1495090" cy="18506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7" name="Object 5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29561726"/>
                </p:ext>
              </p:extLst>
            </p:nvPr>
          </p:nvGraphicFramePr>
          <p:xfrm>
            <a:off x="5585744" y="3979325"/>
            <a:ext cx="1451439" cy="18506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1" imgW="3261029" imgH="4157618" progId="Prism9.Document">
                    <p:embed/>
                  </p:oleObj>
                </mc:Choice>
                <mc:Fallback>
                  <p:oleObj name="Prism 9" r:id="rId41" imgW="3261029" imgH="4157618" progId="Prism9.Document">
                    <p:embed/>
                    <p:pic>
                      <p:nvPicPr>
                        <p:cNvPr id="49" name="Object 48"/>
                        <p:cNvPicPr/>
                        <p:nvPr/>
                      </p:nvPicPr>
                      <p:blipFill>
                        <a:blip r:embed="rId42"/>
                        <a:stretch>
                          <a:fillRect/>
                        </a:stretch>
                      </p:blipFill>
                      <p:spPr>
                        <a:xfrm>
                          <a:off x="5585744" y="3979325"/>
                          <a:ext cx="1451439" cy="18506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0" name="TextBox 99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4232235" y="1397091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4242812" y="2773165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5302216" y="1395405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1C86F33-B20D-EF08-D474-FAF2184E5775}"/>
              </a:ext>
            </a:extLst>
          </p:cNvPr>
          <p:cNvSpPr txBox="1"/>
          <p:nvPr/>
        </p:nvSpPr>
        <p:spPr>
          <a:xfrm>
            <a:off x="5264897" y="2766136"/>
            <a:ext cx="525242" cy="2520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8324D718-FB6D-3A9B-82B4-333777B9DE96}"/>
              </a:ext>
            </a:extLst>
          </p:cNvPr>
          <p:cNvGrpSpPr/>
          <p:nvPr/>
        </p:nvGrpSpPr>
        <p:grpSpPr>
          <a:xfrm>
            <a:off x="-73151" y="1396613"/>
            <a:ext cx="4251729" cy="2668789"/>
            <a:chOff x="-124605" y="69929"/>
            <a:chExt cx="4251729" cy="2668789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76" t="15372" r="1" b="-1"/>
            <a:stretch/>
          </p:blipFill>
          <p:spPr>
            <a:xfrm>
              <a:off x="290090" y="1547408"/>
              <a:ext cx="1187698" cy="118872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4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21" t="15160" b="-2"/>
            <a:stretch/>
          </p:blipFill>
          <p:spPr>
            <a:xfrm>
              <a:off x="1513329" y="1549998"/>
              <a:ext cx="1186870" cy="1188720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4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41" t="14489" r="-536" b="534"/>
            <a:stretch/>
          </p:blipFill>
          <p:spPr>
            <a:xfrm>
              <a:off x="2742608" y="1549998"/>
              <a:ext cx="1191186" cy="1188720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4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59" t="13519"/>
            <a:stretch/>
          </p:blipFill>
          <p:spPr>
            <a:xfrm>
              <a:off x="2742665" y="323293"/>
              <a:ext cx="1186789" cy="118872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39" t="13833" r="535" b="1"/>
            <a:stretch/>
          </p:blipFill>
          <p:spPr>
            <a:xfrm>
              <a:off x="1519444" y="326070"/>
              <a:ext cx="1186833" cy="118872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4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112" t="13868" b="1"/>
            <a:stretch/>
          </p:blipFill>
          <p:spPr>
            <a:xfrm>
              <a:off x="292302" y="324024"/>
              <a:ext cx="1185352" cy="1188720"/>
            </a:xfrm>
            <a:prstGeom prst="rect">
              <a:avLst/>
            </a:prstGeom>
          </p:spPr>
        </p:pic>
        <p:sp>
          <p:nvSpPr>
            <p:cNvPr id="64" name="TextBox 63"/>
            <p:cNvSpPr txBox="1"/>
            <p:nvPr/>
          </p:nvSpPr>
          <p:spPr>
            <a:xfrm>
              <a:off x="294151" y="116513"/>
              <a:ext cx="1179576" cy="2000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Iba1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 rot="5400000">
              <a:off x="3433972" y="810148"/>
              <a:ext cx="1186250" cy="2000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E11.5, 2 dpi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519118" y="119097"/>
              <a:ext cx="1175401" cy="2000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741998" y="119098"/>
              <a:ext cx="1183087" cy="2000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 rot="5400000">
              <a:off x="3434164" y="2043168"/>
              <a:ext cx="1185865" cy="2000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E16.5, 7 dpi</a:t>
              </a:r>
            </a:p>
          </p:txBody>
        </p:sp>
        <p:cxnSp>
          <p:nvCxnSpPr>
            <p:cNvPr id="95" name="Straight Arrow Connector 94"/>
            <p:cNvCxnSpPr/>
            <p:nvPr/>
          </p:nvCxnSpPr>
          <p:spPr>
            <a:xfrm>
              <a:off x="500630" y="582052"/>
              <a:ext cx="37479" cy="12521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Arrow Connector 95"/>
            <p:cNvCxnSpPr/>
            <p:nvPr/>
          </p:nvCxnSpPr>
          <p:spPr>
            <a:xfrm>
              <a:off x="1750350" y="576062"/>
              <a:ext cx="37478" cy="12521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Arrow Connector 96"/>
            <p:cNvCxnSpPr/>
            <p:nvPr/>
          </p:nvCxnSpPr>
          <p:spPr>
            <a:xfrm>
              <a:off x="703526" y="1757508"/>
              <a:ext cx="37479" cy="12521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Arrow Connector 97"/>
            <p:cNvCxnSpPr/>
            <p:nvPr/>
          </p:nvCxnSpPr>
          <p:spPr>
            <a:xfrm>
              <a:off x="3153440" y="1773222"/>
              <a:ext cx="37478" cy="12521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A1C86F33-B20D-EF08-D474-FAF2184E5775}"/>
                </a:ext>
              </a:extLst>
            </p:cNvPr>
            <p:cNvSpPr txBox="1"/>
            <p:nvPr/>
          </p:nvSpPr>
          <p:spPr>
            <a:xfrm>
              <a:off x="-124605" y="69929"/>
              <a:ext cx="525242" cy="2520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cxnSp>
          <p:nvCxnSpPr>
            <p:cNvPr id="105" name="Straight Arrow Connector 104"/>
            <p:cNvCxnSpPr/>
            <p:nvPr/>
          </p:nvCxnSpPr>
          <p:spPr>
            <a:xfrm>
              <a:off x="2963605" y="576062"/>
              <a:ext cx="37478" cy="12521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Arrow Connector 105"/>
            <p:cNvCxnSpPr/>
            <p:nvPr/>
          </p:nvCxnSpPr>
          <p:spPr>
            <a:xfrm>
              <a:off x="1919043" y="1765885"/>
              <a:ext cx="37478" cy="125210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90E3A0D-A4B6-A774-5FCA-CB59D1E40D36}"/>
                </a:ext>
              </a:extLst>
            </p:cNvPr>
            <p:cNvSpPr txBox="1"/>
            <p:nvPr/>
          </p:nvSpPr>
          <p:spPr>
            <a:xfrm rot="16200000">
              <a:off x="-1016934" y="1421837"/>
              <a:ext cx="2414016" cy="2000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solidFill>
                    <a:srgbClr val="2AB70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700" dirty="0">
                  <a:solidFill>
                    <a:srgbClr val="F1252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ba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08385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4</TotalTime>
  <Words>1513</Words>
  <Application>Microsoft Macintosh PowerPoint</Application>
  <PresentationFormat>Custom</PresentationFormat>
  <Paragraphs>114</Paragraphs>
  <Slides>10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Symbol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Illin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tero, Ashley</dc:creator>
  <cp:lastModifiedBy>Otero, Ashley</cp:lastModifiedBy>
  <cp:revision>80</cp:revision>
  <dcterms:created xsi:type="dcterms:W3CDTF">2023-11-07T20:32:36Z</dcterms:created>
  <dcterms:modified xsi:type="dcterms:W3CDTF">2023-12-18T15:59:55Z</dcterms:modified>
</cp:coreProperties>
</file>